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  <Override PartName="/ppt/charts/colors2.xml" ContentType="application/vnd.ms-office.chartcolorstyle+xml"/>
  <Override PartName="/ppt/charts/style2.xml" ContentType="application/vnd.ms-office.chartstyle+xml"/>
  <Override PartName="/ppt/charts/colors3.xml" ContentType="application/vnd.ms-office.chartcolorstyle+xml"/>
  <Override PartName="/ppt/charts/style3.xml" ContentType="application/vnd.ms-office.chartstyle+xml"/>
  <Override PartName="/ppt/charts/colors4.xml" ContentType="application/vnd.ms-office.chartcolorstyle+xml"/>
  <Override PartName="/ppt/charts/style4.xml" ContentType="application/vnd.ms-office.chartstyle+xml"/>
  <Override PartName="/ppt/charts/colors5.xml" ContentType="application/vnd.ms-office.chartcolorstyle+xml"/>
  <Override PartName="/ppt/charts/style5.xml" ContentType="application/vnd.ms-office.chartstyle+xml"/>
  <Override PartName="/ppt/charts/colors6.xml" ContentType="application/vnd.ms-office.chartcolorstyle+xml"/>
  <Override PartName="/ppt/charts/style6.xml" ContentType="application/vnd.ms-office.chartstyle+xml"/>
  <Override PartName="/ppt/charts/colors7.xml" ContentType="application/vnd.ms-office.chartcolorstyle+xml"/>
  <Override PartName="/ppt/charts/style7.xml" ContentType="application/vnd.ms-office.chartstyle+xml"/>
  <Override PartName="/ppt/charts/colors8.xml" ContentType="application/vnd.ms-office.chartcolorstyle+xml"/>
  <Override PartName="/ppt/charts/style8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</p:sldIdLst>
  <p:sldSz cx="9601200" cy="12801600" type="A3"/>
  <p:notesSz cx="9939338" cy="143684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0" autoAdjust="0"/>
    <p:restoredTop sz="94660"/>
  </p:normalViewPr>
  <p:slideViewPr>
    <p:cSldViewPr snapToGrid="0">
      <p:cViewPr>
        <p:scale>
          <a:sx n="66" d="100"/>
          <a:sy n="66" d="100"/>
        </p:scale>
        <p:origin x="-2898" y="-234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C:\Users\akknagai\Dropbox\nagai\&#35542;&#25991;&#28310;&#20633;\181214&#24615;&#24180;&#40802;&#21029;&#12522;&#12473;&#12463;&#12505;&#12493;&#12501;&#12451;&#12483;&#12488;&#34920;&#20316;&#25104;&#29992;an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C:\Users\akknagai\Dropbox\nagai\&#35542;&#25991;&#28310;&#20633;\181214&#24615;&#24180;&#40802;&#21029;&#12522;&#12473;&#12463;&#12505;&#12493;&#12501;&#12451;&#12483;&#12488;&#34920;&#20316;&#25104;&#29992;an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oleObject" Target="file:///C:\Users\akknagai\Dropbox\nagai\&#35542;&#25991;&#28310;&#20633;\181214&#24615;&#24180;&#40802;&#21029;&#12522;&#12473;&#12463;&#12505;&#12493;&#12501;&#12451;&#12483;&#12488;&#34920;&#20316;&#25104;&#29992;an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Style" Target="style4.xml"/><Relationship Id="rId2" Type="http://schemas.microsoft.com/office/2011/relationships/chartColorStyle" Target="colors4.xml"/><Relationship Id="rId1" Type="http://schemas.openxmlformats.org/officeDocument/2006/relationships/oleObject" Target="file:///C:\Users\akknagai\Dropbox\nagai\&#35542;&#25991;&#28310;&#20633;\181214&#24615;&#24180;&#40802;&#21029;&#12522;&#12473;&#12463;&#12505;&#12493;&#12501;&#12451;&#12483;&#12488;&#34920;&#20316;&#25104;&#29992;an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microsoft.com/office/2011/relationships/chartStyle" Target="style5.xml"/><Relationship Id="rId2" Type="http://schemas.microsoft.com/office/2011/relationships/chartColorStyle" Target="colors5.xml"/><Relationship Id="rId1" Type="http://schemas.openxmlformats.org/officeDocument/2006/relationships/oleObject" Target="file:///C:\Users\akknagai\Dropbox\nagai\&#35542;&#25991;&#28310;&#20633;\181214&#24615;&#24180;&#40802;&#21029;&#12522;&#12473;&#12463;&#12505;&#12493;&#12501;&#12451;&#12483;&#12488;&#34920;&#20316;&#25104;&#29992;an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microsoft.com/office/2011/relationships/chartStyle" Target="style6.xml"/><Relationship Id="rId2" Type="http://schemas.microsoft.com/office/2011/relationships/chartColorStyle" Target="colors6.xml"/><Relationship Id="rId1" Type="http://schemas.openxmlformats.org/officeDocument/2006/relationships/oleObject" Target="file:///C:\Users\akknagai\Dropbox\nagai\&#35542;&#25991;&#28310;&#20633;\181214&#24615;&#24180;&#40802;&#21029;&#12522;&#12473;&#12463;&#12505;&#12493;&#12501;&#12451;&#12483;&#12488;&#34920;&#20316;&#25104;&#29992;an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microsoft.com/office/2011/relationships/chartStyle" Target="style7.xml"/><Relationship Id="rId2" Type="http://schemas.microsoft.com/office/2011/relationships/chartColorStyle" Target="colors7.xml"/><Relationship Id="rId1" Type="http://schemas.openxmlformats.org/officeDocument/2006/relationships/oleObject" Target="file:///C:\Users\akknagai\Dropbox\nagai\&#35542;&#25991;&#28310;&#20633;\181214&#24615;&#24180;&#40802;&#21029;&#12522;&#12473;&#12463;&#12505;&#12493;&#12501;&#12451;&#12483;&#12488;&#34920;&#20316;&#25104;&#29992;an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microsoft.com/office/2011/relationships/chartStyle" Target="style8.xml"/><Relationship Id="rId2" Type="http://schemas.microsoft.com/office/2011/relationships/chartColorStyle" Target="colors8.xml"/><Relationship Id="rId1" Type="http://schemas.openxmlformats.org/officeDocument/2006/relationships/oleObject" Target="file:///C:\Users\akknagai\Dropbox\nagai\&#35542;&#25991;&#28310;&#20633;\181214&#24615;&#24180;&#40802;&#21029;&#12522;&#12473;&#12463;&#12505;&#12493;&#12501;&#12451;&#12483;&#12488;&#34920;&#20316;&#25104;&#29992;a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Male, 20-49years old (CPs=34, FMs=136, GAs=1,420)</a:t>
            </a:r>
            <a:endParaRPr lang="ja-JP" sz="100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9.8066444444444428E-2"/>
          <c:y val="2.3368224932249316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benefit_p (color)'!$K$12</c:f>
              <c:strCache>
                <c:ptCount val="1"/>
                <c:pt idx="0">
                  <c:v>Agree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benefit_p (color)'!$I$13:$J$30</c:f>
              <c:multiLvlStrCache>
                <c:ptCount val="18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  <c:pt idx="15">
                    <c:v>CPs</c:v>
                  </c:pt>
                  <c:pt idx="16">
                    <c:v>FMs</c:v>
                  </c:pt>
                  <c:pt idx="17">
                    <c:v>GAs</c:v>
                  </c:pt>
                </c:lvl>
                <c:lvl>
                  <c:pt idx="0">
                    <c:v>It helps to diagnose the type of cancer I have</c:v>
                  </c:pt>
                  <c:pt idx="3">
                    <c:v>It helps to treat the cancer I have</c:v>
                  </c:pt>
                  <c:pt idx="6">
                    <c:v> It helps to diagnose and treat cancers my family has</c:v>
                  </c:pt>
                  <c:pt idx="9">
                    <c:v>If it detects I have a gene for hereditary cancer, it helps to make a future plan</c:v>
                  </c:pt>
                  <c:pt idx="12">
                    <c:v>Cancer precision medicine will become popular</c:v>
                  </c:pt>
                  <c:pt idx="15">
                    <c:v>Registering individual test results in the database helps to enhance the accuracy of the test</c:v>
                  </c:pt>
                </c:lvl>
              </c:multiLvlStrCache>
            </c:multiLvlStrRef>
          </c:cat>
          <c:val>
            <c:numRef>
              <c:f>'benefit_p (color)'!$K$13:$K$30</c:f>
              <c:numCache>
                <c:formatCode>0.0</c:formatCode>
                <c:ptCount val="18"/>
                <c:pt idx="0">
                  <c:v>20.6</c:v>
                </c:pt>
                <c:pt idx="1">
                  <c:v>17.600000000000001</c:v>
                </c:pt>
                <c:pt idx="2">
                  <c:v>9.9</c:v>
                </c:pt>
                <c:pt idx="3">
                  <c:v>23.5</c:v>
                </c:pt>
                <c:pt idx="4">
                  <c:v>20.6</c:v>
                </c:pt>
                <c:pt idx="5">
                  <c:v>10.6</c:v>
                </c:pt>
                <c:pt idx="6">
                  <c:v>17.600000000000001</c:v>
                </c:pt>
                <c:pt idx="7">
                  <c:v>21.3</c:v>
                </c:pt>
                <c:pt idx="8">
                  <c:v>11.2</c:v>
                </c:pt>
                <c:pt idx="9">
                  <c:v>17.600000000000001</c:v>
                </c:pt>
                <c:pt idx="10">
                  <c:v>23.5</c:v>
                </c:pt>
                <c:pt idx="11">
                  <c:v>11.7</c:v>
                </c:pt>
                <c:pt idx="12">
                  <c:v>17.600000000000001</c:v>
                </c:pt>
                <c:pt idx="13">
                  <c:v>32.4</c:v>
                </c:pt>
                <c:pt idx="14">
                  <c:v>14.4</c:v>
                </c:pt>
                <c:pt idx="15">
                  <c:v>20.6</c:v>
                </c:pt>
                <c:pt idx="16">
                  <c:v>26.5</c:v>
                </c:pt>
                <c:pt idx="17">
                  <c:v>12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49D-4BFD-A5F1-58E171F6853A}"/>
            </c:ext>
          </c:extLst>
        </c:ser>
        <c:ser>
          <c:idx val="1"/>
          <c:order val="1"/>
          <c:tx>
            <c:strRef>
              <c:f>'benefit_p (color)'!$L$12</c:f>
              <c:strCache>
                <c:ptCount val="1"/>
                <c:pt idx="0">
                  <c:v>Somewhat agree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benefit_p (color)'!$I$13:$J$30</c:f>
              <c:multiLvlStrCache>
                <c:ptCount val="18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  <c:pt idx="15">
                    <c:v>CPs</c:v>
                  </c:pt>
                  <c:pt idx="16">
                    <c:v>FMs</c:v>
                  </c:pt>
                  <c:pt idx="17">
                    <c:v>GAs</c:v>
                  </c:pt>
                </c:lvl>
                <c:lvl>
                  <c:pt idx="0">
                    <c:v>It helps to diagnose the type of cancer I have</c:v>
                  </c:pt>
                  <c:pt idx="3">
                    <c:v>It helps to treat the cancer I have</c:v>
                  </c:pt>
                  <c:pt idx="6">
                    <c:v> It helps to diagnose and treat cancers my family has</c:v>
                  </c:pt>
                  <c:pt idx="9">
                    <c:v>If it detects I have a gene for hereditary cancer, it helps to make a future plan</c:v>
                  </c:pt>
                  <c:pt idx="12">
                    <c:v>Cancer precision medicine will become popular</c:v>
                  </c:pt>
                  <c:pt idx="15">
                    <c:v>Registering individual test results in the database helps to enhance the accuracy of the test</c:v>
                  </c:pt>
                </c:lvl>
              </c:multiLvlStrCache>
            </c:multiLvlStrRef>
          </c:cat>
          <c:val>
            <c:numRef>
              <c:f>'benefit_p (color)'!$L$13:$L$30</c:f>
              <c:numCache>
                <c:formatCode>0.0</c:formatCode>
                <c:ptCount val="18"/>
                <c:pt idx="0">
                  <c:v>35.299999999999997</c:v>
                </c:pt>
                <c:pt idx="1">
                  <c:v>50.7</c:v>
                </c:pt>
                <c:pt idx="2">
                  <c:v>35.4</c:v>
                </c:pt>
                <c:pt idx="3">
                  <c:v>38.200000000000003</c:v>
                </c:pt>
                <c:pt idx="4">
                  <c:v>47.8</c:v>
                </c:pt>
                <c:pt idx="5">
                  <c:v>36.4</c:v>
                </c:pt>
                <c:pt idx="6">
                  <c:v>29.4</c:v>
                </c:pt>
                <c:pt idx="7">
                  <c:v>47.1</c:v>
                </c:pt>
                <c:pt idx="8">
                  <c:v>37.5</c:v>
                </c:pt>
                <c:pt idx="9">
                  <c:v>38.200000000000003</c:v>
                </c:pt>
                <c:pt idx="10">
                  <c:v>49.3</c:v>
                </c:pt>
                <c:pt idx="11">
                  <c:v>37.700000000000003</c:v>
                </c:pt>
                <c:pt idx="12">
                  <c:v>55.9</c:v>
                </c:pt>
                <c:pt idx="13">
                  <c:v>41.2</c:v>
                </c:pt>
                <c:pt idx="14">
                  <c:v>36.6</c:v>
                </c:pt>
                <c:pt idx="15">
                  <c:v>38.200000000000003</c:v>
                </c:pt>
                <c:pt idx="16">
                  <c:v>45.6</c:v>
                </c:pt>
                <c:pt idx="17">
                  <c:v>37.2999999999999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49D-4BFD-A5F1-58E171F6853A}"/>
            </c:ext>
          </c:extLst>
        </c:ser>
        <c:ser>
          <c:idx val="2"/>
          <c:order val="2"/>
          <c:tx>
            <c:strRef>
              <c:f>'benefit_p (color)'!$M$12</c:f>
              <c:strCache>
                <c:ptCount val="1"/>
                <c:pt idx="0">
                  <c:v>Neither agree nor disagree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benefit_p (color)'!$I$13:$J$30</c:f>
              <c:multiLvlStrCache>
                <c:ptCount val="18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  <c:pt idx="15">
                    <c:v>CPs</c:v>
                  </c:pt>
                  <c:pt idx="16">
                    <c:v>FMs</c:v>
                  </c:pt>
                  <c:pt idx="17">
                    <c:v>GAs</c:v>
                  </c:pt>
                </c:lvl>
                <c:lvl>
                  <c:pt idx="0">
                    <c:v>It helps to diagnose the type of cancer I have</c:v>
                  </c:pt>
                  <c:pt idx="3">
                    <c:v>It helps to treat the cancer I have</c:v>
                  </c:pt>
                  <c:pt idx="6">
                    <c:v> It helps to diagnose and treat cancers my family has</c:v>
                  </c:pt>
                  <c:pt idx="9">
                    <c:v>If it detects I have a gene for hereditary cancer, it helps to make a future plan</c:v>
                  </c:pt>
                  <c:pt idx="12">
                    <c:v>Cancer precision medicine will become popular</c:v>
                  </c:pt>
                  <c:pt idx="15">
                    <c:v>Registering individual test results in the database helps to enhance the accuracy of the test</c:v>
                  </c:pt>
                </c:lvl>
              </c:multiLvlStrCache>
            </c:multiLvlStrRef>
          </c:cat>
          <c:val>
            <c:numRef>
              <c:f>'benefit_p (color)'!$M$13:$M$30</c:f>
              <c:numCache>
                <c:formatCode>0.0</c:formatCode>
                <c:ptCount val="18"/>
                <c:pt idx="0">
                  <c:v>41.2</c:v>
                </c:pt>
                <c:pt idx="1">
                  <c:v>25.7</c:v>
                </c:pt>
                <c:pt idx="2">
                  <c:v>44.8</c:v>
                </c:pt>
                <c:pt idx="3">
                  <c:v>35.299999999999997</c:v>
                </c:pt>
                <c:pt idx="4">
                  <c:v>25.7</c:v>
                </c:pt>
                <c:pt idx="5">
                  <c:v>43.5</c:v>
                </c:pt>
                <c:pt idx="6">
                  <c:v>47.1</c:v>
                </c:pt>
                <c:pt idx="7">
                  <c:v>27.2</c:v>
                </c:pt>
                <c:pt idx="8">
                  <c:v>43</c:v>
                </c:pt>
                <c:pt idx="9">
                  <c:v>41.2</c:v>
                </c:pt>
                <c:pt idx="10">
                  <c:v>25</c:v>
                </c:pt>
                <c:pt idx="11">
                  <c:v>43.2</c:v>
                </c:pt>
                <c:pt idx="12">
                  <c:v>26.5</c:v>
                </c:pt>
                <c:pt idx="13">
                  <c:v>25</c:v>
                </c:pt>
                <c:pt idx="14">
                  <c:v>41.8</c:v>
                </c:pt>
                <c:pt idx="15">
                  <c:v>41.2</c:v>
                </c:pt>
                <c:pt idx="16">
                  <c:v>22.8</c:v>
                </c:pt>
                <c:pt idx="17">
                  <c:v>43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449D-4BFD-A5F1-58E171F6853A}"/>
            </c:ext>
          </c:extLst>
        </c:ser>
        <c:ser>
          <c:idx val="3"/>
          <c:order val="3"/>
          <c:tx>
            <c:strRef>
              <c:f>'benefit_p (color)'!$N$12</c:f>
              <c:strCache>
                <c:ptCount val="1"/>
                <c:pt idx="0">
                  <c:v>Somewhat disagree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benefit_p (color)'!$I$13:$J$30</c:f>
              <c:multiLvlStrCache>
                <c:ptCount val="18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  <c:pt idx="15">
                    <c:v>CPs</c:v>
                  </c:pt>
                  <c:pt idx="16">
                    <c:v>FMs</c:v>
                  </c:pt>
                  <c:pt idx="17">
                    <c:v>GAs</c:v>
                  </c:pt>
                </c:lvl>
                <c:lvl>
                  <c:pt idx="0">
                    <c:v>It helps to diagnose the type of cancer I have</c:v>
                  </c:pt>
                  <c:pt idx="3">
                    <c:v>It helps to treat the cancer I have</c:v>
                  </c:pt>
                  <c:pt idx="6">
                    <c:v> It helps to diagnose and treat cancers my family has</c:v>
                  </c:pt>
                  <c:pt idx="9">
                    <c:v>If it detects I have a gene for hereditary cancer, it helps to make a future plan</c:v>
                  </c:pt>
                  <c:pt idx="12">
                    <c:v>Cancer precision medicine will become popular</c:v>
                  </c:pt>
                  <c:pt idx="15">
                    <c:v>Registering individual test results in the database helps to enhance the accuracy of the test</c:v>
                  </c:pt>
                </c:lvl>
              </c:multiLvlStrCache>
            </c:multiLvlStrRef>
          </c:cat>
          <c:val>
            <c:numRef>
              <c:f>'benefit_p (color)'!$N$13:$N$30</c:f>
              <c:numCache>
                <c:formatCode>0.0</c:formatCode>
                <c:ptCount val="18"/>
                <c:pt idx="1">
                  <c:v>3.7</c:v>
                </c:pt>
                <c:pt idx="2">
                  <c:v>5.8</c:v>
                </c:pt>
                <c:pt idx="3">
                  <c:v>2.9</c:v>
                </c:pt>
                <c:pt idx="4">
                  <c:v>3.7</c:v>
                </c:pt>
                <c:pt idx="5">
                  <c:v>6.5</c:v>
                </c:pt>
                <c:pt idx="6">
                  <c:v>2.9</c:v>
                </c:pt>
                <c:pt idx="7">
                  <c:v>2.2000000000000002</c:v>
                </c:pt>
                <c:pt idx="8">
                  <c:v>5.0999999999999996</c:v>
                </c:pt>
                <c:pt idx="9">
                  <c:v>2.9</c:v>
                </c:pt>
                <c:pt idx="10">
                  <c:v>1.5</c:v>
                </c:pt>
                <c:pt idx="11">
                  <c:v>4.9000000000000004</c:v>
                </c:pt>
                <c:pt idx="13">
                  <c:v>0.7</c:v>
                </c:pt>
                <c:pt idx="14">
                  <c:v>4.9000000000000004</c:v>
                </c:pt>
                <c:pt idx="16">
                  <c:v>3.7</c:v>
                </c:pt>
                <c:pt idx="17">
                  <c:v>4.599999999999999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449D-4BFD-A5F1-58E171F6853A}"/>
            </c:ext>
          </c:extLst>
        </c:ser>
        <c:ser>
          <c:idx val="4"/>
          <c:order val="4"/>
          <c:tx>
            <c:strRef>
              <c:f>'benefit_p (color)'!$O$12</c:f>
              <c:strCache>
                <c:ptCount val="1"/>
                <c:pt idx="0">
                  <c:v>Disagre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multiLvlStrRef>
              <c:f>'benefit_p (color)'!$I$13:$J$30</c:f>
              <c:multiLvlStrCache>
                <c:ptCount val="18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  <c:pt idx="15">
                    <c:v>CPs</c:v>
                  </c:pt>
                  <c:pt idx="16">
                    <c:v>FMs</c:v>
                  </c:pt>
                  <c:pt idx="17">
                    <c:v>GAs</c:v>
                  </c:pt>
                </c:lvl>
                <c:lvl>
                  <c:pt idx="0">
                    <c:v>It helps to diagnose the type of cancer I have</c:v>
                  </c:pt>
                  <c:pt idx="3">
                    <c:v>It helps to treat the cancer I have</c:v>
                  </c:pt>
                  <c:pt idx="6">
                    <c:v> It helps to diagnose and treat cancers my family has</c:v>
                  </c:pt>
                  <c:pt idx="9">
                    <c:v>If it detects I have a gene for hereditary cancer, it helps to make a future plan</c:v>
                  </c:pt>
                  <c:pt idx="12">
                    <c:v>Cancer precision medicine will become popular</c:v>
                  </c:pt>
                  <c:pt idx="15">
                    <c:v>Registering individual test results in the database helps to enhance the accuracy of the test</c:v>
                  </c:pt>
                </c:lvl>
              </c:multiLvlStrCache>
            </c:multiLvlStrRef>
          </c:cat>
          <c:val>
            <c:numRef>
              <c:f>'benefit_p (color)'!$O$13:$O$30</c:f>
              <c:numCache>
                <c:formatCode>0.0</c:formatCode>
                <c:ptCount val="18"/>
                <c:pt idx="0">
                  <c:v>2.9</c:v>
                </c:pt>
                <c:pt idx="1">
                  <c:v>2.2000000000000002</c:v>
                </c:pt>
                <c:pt idx="2">
                  <c:v>4.0999999999999996</c:v>
                </c:pt>
                <c:pt idx="4">
                  <c:v>2.2000000000000002</c:v>
                </c:pt>
                <c:pt idx="5">
                  <c:v>3</c:v>
                </c:pt>
                <c:pt idx="6">
                  <c:v>2.9</c:v>
                </c:pt>
                <c:pt idx="7">
                  <c:v>2.2000000000000002</c:v>
                </c:pt>
                <c:pt idx="8">
                  <c:v>3.1</c:v>
                </c:pt>
                <c:pt idx="10">
                  <c:v>0.7</c:v>
                </c:pt>
                <c:pt idx="11">
                  <c:v>2.5</c:v>
                </c:pt>
                <c:pt idx="13">
                  <c:v>0.7</c:v>
                </c:pt>
                <c:pt idx="14">
                  <c:v>2.2999999999999998</c:v>
                </c:pt>
                <c:pt idx="16">
                  <c:v>1.5</c:v>
                </c:pt>
                <c:pt idx="17">
                  <c:v>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9-449D-4BFD-A5F1-58E171F685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10"/>
        <c:overlap val="100"/>
        <c:axId val="39105536"/>
        <c:axId val="39362560"/>
      </c:barChart>
      <c:catAx>
        <c:axId val="391055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362560"/>
        <c:crosses val="autoZero"/>
        <c:auto val="1"/>
        <c:lblAlgn val="ctr"/>
        <c:lblOffset val="100"/>
        <c:noMultiLvlLbl val="0"/>
      </c:catAx>
      <c:valAx>
        <c:axId val="393625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Narrow" panose="020B060602020203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1055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Arial Narrow" panose="020B060602020203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Female, 20-49years old (CPs=183, FMs=209, GAs=1,051)</a:t>
            </a:r>
          </a:p>
        </c:rich>
      </c:tx>
      <c:layout>
        <c:manualLayout>
          <c:xMode val="edge"/>
          <c:yMode val="edge"/>
          <c:x val="0.10644044444444445"/>
          <c:y val="2.5476964769647698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8.9763555555555555E-2"/>
          <c:y val="0.12134281842818426"/>
          <c:w val="0.87919199999999997"/>
          <c:h val="0.4709247967479675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benefit_p (color)'!$K$106</c:f>
              <c:strCache>
                <c:ptCount val="1"/>
                <c:pt idx="0">
                  <c:v>Agree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benefit_p (color)'!$I$107:$J$124</c:f>
              <c:multiLvlStrCache>
                <c:ptCount val="18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  <c:pt idx="15">
                    <c:v>CPs</c:v>
                  </c:pt>
                  <c:pt idx="16">
                    <c:v>FMs</c:v>
                  </c:pt>
                  <c:pt idx="17">
                    <c:v>GAs</c:v>
                  </c:pt>
                </c:lvl>
                <c:lvl>
                  <c:pt idx="0">
                    <c:v>It helps to diagnose the type of cancer I have</c:v>
                  </c:pt>
                  <c:pt idx="3">
                    <c:v>It helps to treat the cancer I have</c:v>
                  </c:pt>
                  <c:pt idx="6">
                    <c:v> It helps to diagnose and treat cancers my family has</c:v>
                  </c:pt>
                  <c:pt idx="9">
                    <c:v>If it detects I have a gene for hereditary cancer, it helps to make a future plan</c:v>
                  </c:pt>
                  <c:pt idx="12">
                    <c:v>Cancer precision medicine will become popular</c:v>
                  </c:pt>
                  <c:pt idx="15">
                    <c:v>Registering individual test results in the database helps to enhance the accuracy of the test</c:v>
                  </c:pt>
                </c:lvl>
              </c:multiLvlStrCache>
            </c:multiLvlStrRef>
          </c:cat>
          <c:val>
            <c:numRef>
              <c:f>'benefit_p (color)'!$K$107:$K$124</c:f>
              <c:numCache>
                <c:formatCode>0.0</c:formatCode>
                <c:ptCount val="18"/>
                <c:pt idx="0">
                  <c:v>15.3</c:v>
                </c:pt>
                <c:pt idx="1">
                  <c:v>15.3</c:v>
                </c:pt>
                <c:pt idx="2">
                  <c:v>8.9</c:v>
                </c:pt>
                <c:pt idx="3">
                  <c:v>14.2</c:v>
                </c:pt>
                <c:pt idx="4">
                  <c:v>21.5</c:v>
                </c:pt>
                <c:pt idx="5">
                  <c:v>11.5</c:v>
                </c:pt>
                <c:pt idx="6">
                  <c:v>11.5</c:v>
                </c:pt>
                <c:pt idx="7">
                  <c:v>23.9</c:v>
                </c:pt>
                <c:pt idx="8">
                  <c:v>11.8</c:v>
                </c:pt>
                <c:pt idx="9">
                  <c:v>16.899999999999999</c:v>
                </c:pt>
                <c:pt idx="10">
                  <c:v>23</c:v>
                </c:pt>
                <c:pt idx="11">
                  <c:v>13.5</c:v>
                </c:pt>
                <c:pt idx="12">
                  <c:v>25.7</c:v>
                </c:pt>
                <c:pt idx="13">
                  <c:v>27.3</c:v>
                </c:pt>
                <c:pt idx="14">
                  <c:v>14.7</c:v>
                </c:pt>
                <c:pt idx="15">
                  <c:v>20.8</c:v>
                </c:pt>
                <c:pt idx="16">
                  <c:v>21.5</c:v>
                </c:pt>
                <c:pt idx="17">
                  <c:v>12.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C14-4CAA-95BA-6B7CA6552CD2}"/>
            </c:ext>
          </c:extLst>
        </c:ser>
        <c:ser>
          <c:idx val="1"/>
          <c:order val="1"/>
          <c:tx>
            <c:strRef>
              <c:f>'benefit_p (color)'!$L$106</c:f>
              <c:strCache>
                <c:ptCount val="1"/>
                <c:pt idx="0">
                  <c:v>Somewhat agree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benefit_p (color)'!$I$107:$J$124</c:f>
              <c:multiLvlStrCache>
                <c:ptCount val="18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  <c:pt idx="15">
                    <c:v>CPs</c:v>
                  </c:pt>
                  <c:pt idx="16">
                    <c:v>FMs</c:v>
                  </c:pt>
                  <c:pt idx="17">
                    <c:v>GAs</c:v>
                  </c:pt>
                </c:lvl>
                <c:lvl>
                  <c:pt idx="0">
                    <c:v>It helps to diagnose the type of cancer I have</c:v>
                  </c:pt>
                  <c:pt idx="3">
                    <c:v>It helps to treat the cancer I have</c:v>
                  </c:pt>
                  <c:pt idx="6">
                    <c:v> It helps to diagnose and treat cancers my family has</c:v>
                  </c:pt>
                  <c:pt idx="9">
                    <c:v>If it detects I have a gene for hereditary cancer, it helps to make a future plan</c:v>
                  </c:pt>
                  <c:pt idx="12">
                    <c:v>Cancer precision medicine will become popular</c:v>
                  </c:pt>
                  <c:pt idx="15">
                    <c:v>Registering individual test results in the database helps to enhance the accuracy of the test</c:v>
                  </c:pt>
                </c:lvl>
              </c:multiLvlStrCache>
            </c:multiLvlStrRef>
          </c:cat>
          <c:val>
            <c:numRef>
              <c:f>'benefit_p (color)'!$L$107:$L$124</c:f>
              <c:numCache>
                <c:formatCode>0.0</c:formatCode>
                <c:ptCount val="18"/>
                <c:pt idx="0">
                  <c:v>51.4</c:v>
                </c:pt>
                <c:pt idx="1">
                  <c:v>57.4</c:v>
                </c:pt>
                <c:pt idx="2">
                  <c:v>43.8</c:v>
                </c:pt>
                <c:pt idx="3">
                  <c:v>51.9</c:v>
                </c:pt>
                <c:pt idx="4">
                  <c:v>58.9</c:v>
                </c:pt>
                <c:pt idx="5">
                  <c:v>42</c:v>
                </c:pt>
                <c:pt idx="6">
                  <c:v>48.1</c:v>
                </c:pt>
                <c:pt idx="7">
                  <c:v>55.5</c:v>
                </c:pt>
                <c:pt idx="8">
                  <c:v>44.4</c:v>
                </c:pt>
                <c:pt idx="9">
                  <c:v>55.7</c:v>
                </c:pt>
                <c:pt idx="10">
                  <c:v>57.4</c:v>
                </c:pt>
                <c:pt idx="11">
                  <c:v>44.1</c:v>
                </c:pt>
                <c:pt idx="12">
                  <c:v>57.4</c:v>
                </c:pt>
                <c:pt idx="13">
                  <c:v>56.5</c:v>
                </c:pt>
                <c:pt idx="14">
                  <c:v>44.9</c:v>
                </c:pt>
                <c:pt idx="15">
                  <c:v>54.1</c:v>
                </c:pt>
                <c:pt idx="16">
                  <c:v>58.4</c:v>
                </c:pt>
                <c:pt idx="17">
                  <c:v>41.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C14-4CAA-95BA-6B7CA6552CD2}"/>
            </c:ext>
          </c:extLst>
        </c:ser>
        <c:ser>
          <c:idx val="2"/>
          <c:order val="2"/>
          <c:tx>
            <c:strRef>
              <c:f>'benefit_p (color)'!$M$106</c:f>
              <c:strCache>
                <c:ptCount val="1"/>
                <c:pt idx="0">
                  <c:v>Neither agree nor disagree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benefit_p (color)'!$I$107:$J$124</c:f>
              <c:multiLvlStrCache>
                <c:ptCount val="18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  <c:pt idx="15">
                    <c:v>CPs</c:v>
                  </c:pt>
                  <c:pt idx="16">
                    <c:v>FMs</c:v>
                  </c:pt>
                  <c:pt idx="17">
                    <c:v>GAs</c:v>
                  </c:pt>
                </c:lvl>
                <c:lvl>
                  <c:pt idx="0">
                    <c:v>It helps to diagnose the type of cancer I have</c:v>
                  </c:pt>
                  <c:pt idx="3">
                    <c:v>It helps to treat the cancer I have</c:v>
                  </c:pt>
                  <c:pt idx="6">
                    <c:v> It helps to diagnose and treat cancers my family has</c:v>
                  </c:pt>
                  <c:pt idx="9">
                    <c:v>If it detects I have a gene for hereditary cancer, it helps to make a future plan</c:v>
                  </c:pt>
                  <c:pt idx="12">
                    <c:v>Cancer precision medicine will become popular</c:v>
                  </c:pt>
                  <c:pt idx="15">
                    <c:v>Registering individual test results in the database helps to enhance the accuracy of the test</c:v>
                  </c:pt>
                </c:lvl>
              </c:multiLvlStrCache>
            </c:multiLvlStrRef>
          </c:cat>
          <c:val>
            <c:numRef>
              <c:f>'benefit_p (color)'!$M$107:$M$124</c:f>
              <c:numCache>
                <c:formatCode>0.0</c:formatCode>
                <c:ptCount val="18"/>
                <c:pt idx="0">
                  <c:v>30.6</c:v>
                </c:pt>
                <c:pt idx="1">
                  <c:v>21.1</c:v>
                </c:pt>
                <c:pt idx="2">
                  <c:v>37.4</c:v>
                </c:pt>
                <c:pt idx="3">
                  <c:v>27.3</c:v>
                </c:pt>
                <c:pt idx="4">
                  <c:v>14.8</c:v>
                </c:pt>
                <c:pt idx="5">
                  <c:v>38.4</c:v>
                </c:pt>
                <c:pt idx="6">
                  <c:v>35</c:v>
                </c:pt>
                <c:pt idx="7">
                  <c:v>17.7</c:v>
                </c:pt>
                <c:pt idx="8">
                  <c:v>36.700000000000003</c:v>
                </c:pt>
                <c:pt idx="9">
                  <c:v>26.2</c:v>
                </c:pt>
                <c:pt idx="10">
                  <c:v>17.7</c:v>
                </c:pt>
                <c:pt idx="11">
                  <c:v>35.799999999999997</c:v>
                </c:pt>
                <c:pt idx="12">
                  <c:v>15.3</c:v>
                </c:pt>
                <c:pt idx="13">
                  <c:v>15.3</c:v>
                </c:pt>
                <c:pt idx="14">
                  <c:v>34.799999999999997</c:v>
                </c:pt>
                <c:pt idx="15">
                  <c:v>23.5</c:v>
                </c:pt>
                <c:pt idx="16">
                  <c:v>19.100000000000001</c:v>
                </c:pt>
                <c:pt idx="17">
                  <c:v>38.7999999999999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C14-4CAA-95BA-6B7CA6552CD2}"/>
            </c:ext>
          </c:extLst>
        </c:ser>
        <c:ser>
          <c:idx val="3"/>
          <c:order val="3"/>
          <c:tx>
            <c:strRef>
              <c:f>'benefit_p (color)'!$N$106</c:f>
              <c:strCache>
                <c:ptCount val="1"/>
                <c:pt idx="0">
                  <c:v>Somewhat disagree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benefit_p (color)'!$I$107:$J$124</c:f>
              <c:multiLvlStrCache>
                <c:ptCount val="18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  <c:pt idx="15">
                    <c:v>CPs</c:v>
                  </c:pt>
                  <c:pt idx="16">
                    <c:v>FMs</c:v>
                  </c:pt>
                  <c:pt idx="17">
                    <c:v>GAs</c:v>
                  </c:pt>
                </c:lvl>
                <c:lvl>
                  <c:pt idx="0">
                    <c:v>It helps to diagnose the type of cancer I have</c:v>
                  </c:pt>
                  <c:pt idx="3">
                    <c:v>It helps to treat the cancer I have</c:v>
                  </c:pt>
                  <c:pt idx="6">
                    <c:v> It helps to diagnose and treat cancers my family has</c:v>
                  </c:pt>
                  <c:pt idx="9">
                    <c:v>If it detects I have a gene for hereditary cancer, it helps to make a future plan</c:v>
                  </c:pt>
                  <c:pt idx="12">
                    <c:v>Cancer precision medicine will become popular</c:v>
                  </c:pt>
                  <c:pt idx="15">
                    <c:v>Registering individual test results in the database helps to enhance the accuracy of the test</c:v>
                  </c:pt>
                </c:lvl>
              </c:multiLvlStrCache>
            </c:multiLvlStrRef>
          </c:cat>
          <c:val>
            <c:numRef>
              <c:f>'benefit_p (color)'!$N$107:$N$124</c:f>
              <c:numCache>
                <c:formatCode>0.0</c:formatCode>
                <c:ptCount val="18"/>
                <c:pt idx="0">
                  <c:v>1.6</c:v>
                </c:pt>
                <c:pt idx="1">
                  <c:v>3.8</c:v>
                </c:pt>
                <c:pt idx="2">
                  <c:v>5.5</c:v>
                </c:pt>
                <c:pt idx="3">
                  <c:v>4.9000000000000004</c:v>
                </c:pt>
                <c:pt idx="4">
                  <c:v>2.4</c:v>
                </c:pt>
                <c:pt idx="5">
                  <c:v>4.8</c:v>
                </c:pt>
                <c:pt idx="6">
                  <c:v>3.3</c:v>
                </c:pt>
                <c:pt idx="7">
                  <c:v>1.4</c:v>
                </c:pt>
                <c:pt idx="8">
                  <c:v>3.9</c:v>
                </c:pt>
                <c:pt idx="9">
                  <c:v>0.5</c:v>
                </c:pt>
                <c:pt idx="10">
                  <c:v>1</c:v>
                </c:pt>
                <c:pt idx="11">
                  <c:v>3.7</c:v>
                </c:pt>
                <c:pt idx="12">
                  <c:v>0.5</c:v>
                </c:pt>
                <c:pt idx="13">
                  <c:v>1</c:v>
                </c:pt>
                <c:pt idx="14">
                  <c:v>3.3</c:v>
                </c:pt>
                <c:pt idx="15">
                  <c:v>1.1000000000000001</c:v>
                </c:pt>
                <c:pt idx="16">
                  <c:v>1</c:v>
                </c:pt>
                <c:pt idx="17">
                  <c:v>4.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BC14-4CAA-95BA-6B7CA6552CD2}"/>
            </c:ext>
          </c:extLst>
        </c:ser>
        <c:ser>
          <c:idx val="4"/>
          <c:order val="4"/>
          <c:tx>
            <c:strRef>
              <c:f>'benefit_p (color)'!$O$106</c:f>
              <c:strCache>
                <c:ptCount val="1"/>
                <c:pt idx="0">
                  <c:v>Disagre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multiLvlStrRef>
              <c:f>'benefit_p (color)'!$I$107:$J$124</c:f>
              <c:multiLvlStrCache>
                <c:ptCount val="18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  <c:pt idx="15">
                    <c:v>CPs</c:v>
                  </c:pt>
                  <c:pt idx="16">
                    <c:v>FMs</c:v>
                  </c:pt>
                  <c:pt idx="17">
                    <c:v>GAs</c:v>
                  </c:pt>
                </c:lvl>
                <c:lvl>
                  <c:pt idx="0">
                    <c:v>It helps to diagnose the type of cancer I have</c:v>
                  </c:pt>
                  <c:pt idx="3">
                    <c:v>It helps to treat the cancer I have</c:v>
                  </c:pt>
                  <c:pt idx="6">
                    <c:v> It helps to diagnose and treat cancers my family has</c:v>
                  </c:pt>
                  <c:pt idx="9">
                    <c:v>If it detects I have a gene for hereditary cancer, it helps to make a future plan</c:v>
                  </c:pt>
                  <c:pt idx="12">
                    <c:v>Cancer precision medicine will become popular</c:v>
                  </c:pt>
                  <c:pt idx="15">
                    <c:v>Registering individual test results in the database helps to enhance the accuracy of the test</c:v>
                  </c:pt>
                </c:lvl>
              </c:multiLvlStrCache>
            </c:multiLvlStrRef>
          </c:cat>
          <c:val>
            <c:numRef>
              <c:f>'benefit_p (color)'!$O$107:$O$124</c:f>
              <c:numCache>
                <c:formatCode>0.0</c:formatCode>
                <c:ptCount val="18"/>
                <c:pt idx="0">
                  <c:v>1.1000000000000001</c:v>
                </c:pt>
                <c:pt idx="1">
                  <c:v>2.4</c:v>
                </c:pt>
                <c:pt idx="2">
                  <c:v>4.4000000000000004</c:v>
                </c:pt>
                <c:pt idx="3">
                  <c:v>1.6</c:v>
                </c:pt>
                <c:pt idx="4">
                  <c:v>2.4</c:v>
                </c:pt>
                <c:pt idx="5">
                  <c:v>3.3</c:v>
                </c:pt>
                <c:pt idx="6">
                  <c:v>2.2000000000000002</c:v>
                </c:pt>
                <c:pt idx="7">
                  <c:v>1.4</c:v>
                </c:pt>
                <c:pt idx="8">
                  <c:v>3.1</c:v>
                </c:pt>
                <c:pt idx="9">
                  <c:v>0.5</c:v>
                </c:pt>
                <c:pt idx="10">
                  <c:v>1</c:v>
                </c:pt>
                <c:pt idx="11">
                  <c:v>2.9</c:v>
                </c:pt>
                <c:pt idx="12">
                  <c:v>1.1000000000000001</c:v>
                </c:pt>
                <c:pt idx="14">
                  <c:v>2.2000000000000002</c:v>
                </c:pt>
                <c:pt idx="15">
                  <c:v>0.5</c:v>
                </c:pt>
                <c:pt idx="17">
                  <c:v>2.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9-BC14-4CAA-95BA-6B7CA6552C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10"/>
        <c:overlap val="100"/>
        <c:axId val="39106560"/>
        <c:axId val="39366592"/>
      </c:barChart>
      <c:catAx>
        <c:axId val="391065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366592"/>
        <c:crosses val="autoZero"/>
        <c:auto val="1"/>
        <c:lblAlgn val="ctr"/>
        <c:lblOffset val="100"/>
        <c:noMultiLvlLbl val="0"/>
      </c:catAx>
      <c:valAx>
        <c:axId val="393665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1065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/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00" b="0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Female, 50-69years old</a:t>
            </a:r>
            <a:r>
              <a:rPr lang="en-US" altLang="ja-JP" sz="1000" b="0" i="0" baseline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CPs=316, FMs=201, GAs=532)</a:t>
            </a:r>
            <a:endParaRPr lang="ja-JP" altLang="ja-JP" sz="100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0518888888888889"/>
          <c:y val="2.1174796747967479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8.9763555555555555E-2"/>
          <c:y val="0.12564498644986449"/>
          <c:w val="0.87919199999999997"/>
          <c:h val="0.46662262872628724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benefit_p (color)'!$K$158</c:f>
              <c:strCache>
                <c:ptCount val="1"/>
                <c:pt idx="0">
                  <c:v>Agree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benefit_p (color)'!$I$159:$J$176</c:f>
              <c:multiLvlStrCache>
                <c:ptCount val="18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  <c:pt idx="15">
                    <c:v>CPs</c:v>
                  </c:pt>
                  <c:pt idx="16">
                    <c:v>FMs</c:v>
                  </c:pt>
                  <c:pt idx="17">
                    <c:v>GAs</c:v>
                  </c:pt>
                </c:lvl>
                <c:lvl>
                  <c:pt idx="0">
                    <c:v>It helps to diagnose the type of cancer I have</c:v>
                  </c:pt>
                  <c:pt idx="3">
                    <c:v>It helps to treat the cancer I have</c:v>
                  </c:pt>
                  <c:pt idx="6">
                    <c:v> It helps to diagnose and treat cancers my family has</c:v>
                  </c:pt>
                  <c:pt idx="9">
                    <c:v>If it detects I have a gene for hereditary cancer, it helps to make a future plan</c:v>
                  </c:pt>
                  <c:pt idx="12">
                    <c:v>Cancer precision medicine will become popular</c:v>
                  </c:pt>
                  <c:pt idx="15">
                    <c:v>Registering individual test results in the database helps to enhance the accuracy of the test</c:v>
                  </c:pt>
                </c:lvl>
              </c:multiLvlStrCache>
            </c:multiLvlStrRef>
          </c:cat>
          <c:val>
            <c:numRef>
              <c:f>'benefit_p (color)'!$K$159:$K$176</c:f>
              <c:numCache>
                <c:formatCode>0.0</c:formatCode>
                <c:ptCount val="18"/>
                <c:pt idx="0">
                  <c:v>9.8000000000000007</c:v>
                </c:pt>
                <c:pt idx="1">
                  <c:v>12.9</c:v>
                </c:pt>
                <c:pt idx="2">
                  <c:v>7.3</c:v>
                </c:pt>
                <c:pt idx="3">
                  <c:v>7.3</c:v>
                </c:pt>
                <c:pt idx="4">
                  <c:v>12.9</c:v>
                </c:pt>
                <c:pt idx="5">
                  <c:v>7.9</c:v>
                </c:pt>
                <c:pt idx="6">
                  <c:v>6.6</c:v>
                </c:pt>
                <c:pt idx="7">
                  <c:v>16.899999999999999</c:v>
                </c:pt>
                <c:pt idx="8">
                  <c:v>8.8000000000000007</c:v>
                </c:pt>
                <c:pt idx="9">
                  <c:v>13.3</c:v>
                </c:pt>
                <c:pt idx="10">
                  <c:v>16.399999999999999</c:v>
                </c:pt>
                <c:pt idx="11">
                  <c:v>11.8</c:v>
                </c:pt>
                <c:pt idx="12">
                  <c:v>18.7</c:v>
                </c:pt>
                <c:pt idx="13">
                  <c:v>18.899999999999999</c:v>
                </c:pt>
                <c:pt idx="14">
                  <c:v>13.2</c:v>
                </c:pt>
                <c:pt idx="15">
                  <c:v>17.399999999999999</c:v>
                </c:pt>
                <c:pt idx="16">
                  <c:v>17.399999999999999</c:v>
                </c:pt>
                <c:pt idx="17">
                  <c:v>9.800000000000000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C14-4CAA-95BA-6B7CA6552CD2}"/>
            </c:ext>
          </c:extLst>
        </c:ser>
        <c:ser>
          <c:idx val="1"/>
          <c:order val="1"/>
          <c:tx>
            <c:strRef>
              <c:f>'benefit_p (color)'!$L$158</c:f>
              <c:strCache>
                <c:ptCount val="1"/>
                <c:pt idx="0">
                  <c:v>Somewhat agree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benefit_p (color)'!$I$159:$J$176</c:f>
              <c:multiLvlStrCache>
                <c:ptCount val="18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  <c:pt idx="15">
                    <c:v>CPs</c:v>
                  </c:pt>
                  <c:pt idx="16">
                    <c:v>FMs</c:v>
                  </c:pt>
                  <c:pt idx="17">
                    <c:v>GAs</c:v>
                  </c:pt>
                </c:lvl>
                <c:lvl>
                  <c:pt idx="0">
                    <c:v>It helps to diagnose the type of cancer I have</c:v>
                  </c:pt>
                  <c:pt idx="3">
                    <c:v>It helps to treat the cancer I have</c:v>
                  </c:pt>
                  <c:pt idx="6">
                    <c:v> It helps to diagnose and treat cancers my family has</c:v>
                  </c:pt>
                  <c:pt idx="9">
                    <c:v>If it detects I have a gene for hereditary cancer, it helps to make a future plan</c:v>
                  </c:pt>
                  <c:pt idx="12">
                    <c:v>Cancer precision medicine will become popular</c:v>
                  </c:pt>
                  <c:pt idx="15">
                    <c:v>Registering individual test results in the database helps to enhance the accuracy of the test</c:v>
                  </c:pt>
                </c:lvl>
              </c:multiLvlStrCache>
            </c:multiLvlStrRef>
          </c:cat>
          <c:val>
            <c:numRef>
              <c:f>'benefit_p (color)'!$L$159:$L$176</c:f>
              <c:numCache>
                <c:formatCode>0.0</c:formatCode>
                <c:ptCount val="18"/>
                <c:pt idx="0">
                  <c:v>45.6</c:v>
                </c:pt>
                <c:pt idx="1">
                  <c:v>59.2</c:v>
                </c:pt>
                <c:pt idx="2">
                  <c:v>44.9</c:v>
                </c:pt>
                <c:pt idx="3">
                  <c:v>44.9</c:v>
                </c:pt>
                <c:pt idx="4">
                  <c:v>57.2</c:v>
                </c:pt>
                <c:pt idx="5">
                  <c:v>44.5</c:v>
                </c:pt>
                <c:pt idx="6">
                  <c:v>41.8</c:v>
                </c:pt>
                <c:pt idx="7">
                  <c:v>58.2</c:v>
                </c:pt>
                <c:pt idx="8">
                  <c:v>45.7</c:v>
                </c:pt>
                <c:pt idx="9">
                  <c:v>56.3</c:v>
                </c:pt>
                <c:pt idx="10">
                  <c:v>59.2</c:v>
                </c:pt>
                <c:pt idx="11">
                  <c:v>46.2</c:v>
                </c:pt>
                <c:pt idx="12">
                  <c:v>60.1</c:v>
                </c:pt>
                <c:pt idx="13">
                  <c:v>61.7</c:v>
                </c:pt>
                <c:pt idx="14">
                  <c:v>45.9</c:v>
                </c:pt>
                <c:pt idx="15">
                  <c:v>57.6</c:v>
                </c:pt>
                <c:pt idx="16">
                  <c:v>58.2</c:v>
                </c:pt>
                <c:pt idx="17">
                  <c:v>45.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C14-4CAA-95BA-6B7CA6552CD2}"/>
            </c:ext>
          </c:extLst>
        </c:ser>
        <c:ser>
          <c:idx val="2"/>
          <c:order val="2"/>
          <c:tx>
            <c:strRef>
              <c:f>'benefit_p (color)'!$M$158</c:f>
              <c:strCache>
                <c:ptCount val="1"/>
                <c:pt idx="0">
                  <c:v>Neither agree nor disagree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benefit_p (color)'!$I$159:$J$176</c:f>
              <c:multiLvlStrCache>
                <c:ptCount val="18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  <c:pt idx="15">
                    <c:v>CPs</c:v>
                  </c:pt>
                  <c:pt idx="16">
                    <c:v>FMs</c:v>
                  </c:pt>
                  <c:pt idx="17">
                    <c:v>GAs</c:v>
                  </c:pt>
                </c:lvl>
                <c:lvl>
                  <c:pt idx="0">
                    <c:v>It helps to diagnose the type of cancer I have</c:v>
                  </c:pt>
                  <c:pt idx="3">
                    <c:v>It helps to treat the cancer I have</c:v>
                  </c:pt>
                  <c:pt idx="6">
                    <c:v> It helps to diagnose and treat cancers my family has</c:v>
                  </c:pt>
                  <c:pt idx="9">
                    <c:v>If it detects I have a gene for hereditary cancer, it helps to make a future plan</c:v>
                  </c:pt>
                  <c:pt idx="12">
                    <c:v>Cancer precision medicine will become popular</c:v>
                  </c:pt>
                  <c:pt idx="15">
                    <c:v>Registering individual test results in the database helps to enhance the accuracy of the test</c:v>
                  </c:pt>
                </c:lvl>
              </c:multiLvlStrCache>
            </c:multiLvlStrRef>
          </c:cat>
          <c:val>
            <c:numRef>
              <c:f>'benefit_p (color)'!$M$159:$M$176</c:f>
              <c:numCache>
                <c:formatCode>0.0</c:formatCode>
                <c:ptCount val="18"/>
                <c:pt idx="0">
                  <c:v>37.700000000000003</c:v>
                </c:pt>
                <c:pt idx="1">
                  <c:v>25.4</c:v>
                </c:pt>
                <c:pt idx="2">
                  <c:v>41.4</c:v>
                </c:pt>
                <c:pt idx="3">
                  <c:v>37.700000000000003</c:v>
                </c:pt>
                <c:pt idx="4">
                  <c:v>26.4</c:v>
                </c:pt>
                <c:pt idx="5">
                  <c:v>41.7</c:v>
                </c:pt>
                <c:pt idx="6">
                  <c:v>41.8</c:v>
                </c:pt>
                <c:pt idx="7">
                  <c:v>21.4</c:v>
                </c:pt>
                <c:pt idx="8">
                  <c:v>41</c:v>
                </c:pt>
                <c:pt idx="9">
                  <c:v>26.6</c:v>
                </c:pt>
                <c:pt idx="10">
                  <c:v>21.9</c:v>
                </c:pt>
                <c:pt idx="11">
                  <c:v>37.799999999999997</c:v>
                </c:pt>
                <c:pt idx="12">
                  <c:v>18.7</c:v>
                </c:pt>
                <c:pt idx="13">
                  <c:v>17.399999999999999</c:v>
                </c:pt>
                <c:pt idx="14">
                  <c:v>37</c:v>
                </c:pt>
                <c:pt idx="15">
                  <c:v>23.1</c:v>
                </c:pt>
                <c:pt idx="16">
                  <c:v>21.9</c:v>
                </c:pt>
                <c:pt idx="17">
                  <c:v>39.70000000000000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C14-4CAA-95BA-6B7CA6552CD2}"/>
            </c:ext>
          </c:extLst>
        </c:ser>
        <c:ser>
          <c:idx val="3"/>
          <c:order val="3"/>
          <c:tx>
            <c:strRef>
              <c:f>'benefit_p (color)'!$N$158</c:f>
              <c:strCache>
                <c:ptCount val="1"/>
                <c:pt idx="0">
                  <c:v>Somewhat disagree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benefit_p (color)'!$I$159:$J$176</c:f>
              <c:multiLvlStrCache>
                <c:ptCount val="18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  <c:pt idx="15">
                    <c:v>CPs</c:v>
                  </c:pt>
                  <c:pt idx="16">
                    <c:v>FMs</c:v>
                  </c:pt>
                  <c:pt idx="17">
                    <c:v>GAs</c:v>
                  </c:pt>
                </c:lvl>
                <c:lvl>
                  <c:pt idx="0">
                    <c:v>It helps to diagnose the type of cancer I have</c:v>
                  </c:pt>
                  <c:pt idx="3">
                    <c:v>It helps to treat the cancer I have</c:v>
                  </c:pt>
                  <c:pt idx="6">
                    <c:v> It helps to diagnose and treat cancers my family has</c:v>
                  </c:pt>
                  <c:pt idx="9">
                    <c:v>If it detects I have a gene for hereditary cancer, it helps to make a future plan</c:v>
                  </c:pt>
                  <c:pt idx="12">
                    <c:v>Cancer precision medicine will become popular</c:v>
                  </c:pt>
                  <c:pt idx="15">
                    <c:v>Registering individual test results in the database helps to enhance the accuracy of the test</c:v>
                  </c:pt>
                </c:lvl>
              </c:multiLvlStrCache>
            </c:multiLvlStrRef>
          </c:cat>
          <c:val>
            <c:numRef>
              <c:f>'benefit_p (color)'!$N$159:$N$176</c:f>
              <c:numCache>
                <c:formatCode>0.0</c:formatCode>
                <c:ptCount val="18"/>
                <c:pt idx="0">
                  <c:v>6</c:v>
                </c:pt>
                <c:pt idx="1">
                  <c:v>2.5</c:v>
                </c:pt>
                <c:pt idx="2">
                  <c:v>3.2</c:v>
                </c:pt>
                <c:pt idx="3">
                  <c:v>8.9</c:v>
                </c:pt>
                <c:pt idx="4">
                  <c:v>2.5</c:v>
                </c:pt>
                <c:pt idx="5">
                  <c:v>3</c:v>
                </c:pt>
                <c:pt idx="6">
                  <c:v>5.7</c:v>
                </c:pt>
                <c:pt idx="7">
                  <c:v>3</c:v>
                </c:pt>
                <c:pt idx="8">
                  <c:v>2.1</c:v>
                </c:pt>
                <c:pt idx="9">
                  <c:v>3.2</c:v>
                </c:pt>
                <c:pt idx="10">
                  <c:v>2</c:v>
                </c:pt>
                <c:pt idx="11">
                  <c:v>2.2999999999999998</c:v>
                </c:pt>
                <c:pt idx="12">
                  <c:v>1.9</c:v>
                </c:pt>
                <c:pt idx="13">
                  <c:v>2</c:v>
                </c:pt>
                <c:pt idx="14">
                  <c:v>2.6</c:v>
                </c:pt>
                <c:pt idx="15">
                  <c:v>1.9</c:v>
                </c:pt>
                <c:pt idx="16">
                  <c:v>2.5</c:v>
                </c:pt>
                <c:pt idx="17">
                  <c:v>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BC14-4CAA-95BA-6B7CA6552CD2}"/>
            </c:ext>
          </c:extLst>
        </c:ser>
        <c:ser>
          <c:idx val="4"/>
          <c:order val="4"/>
          <c:tx>
            <c:strRef>
              <c:f>'benefit_p (color)'!$O$158</c:f>
              <c:strCache>
                <c:ptCount val="1"/>
                <c:pt idx="0">
                  <c:v>Disagre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multiLvlStrRef>
              <c:f>'benefit_p (color)'!$I$159:$J$176</c:f>
              <c:multiLvlStrCache>
                <c:ptCount val="18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  <c:pt idx="15">
                    <c:v>CPs</c:v>
                  </c:pt>
                  <c:pt idx="16">
                    <c:v>FMs</c:v>
                  </c:pt>
                  <c:pt idx="17">
                    <c:v>GAs</c:v>
                  </c:pt>
                </c:lvl>
                <c:lvl>
                  <c:pt idx="0">
                    <c:v>It helps to diagnose the type of cancer I have</c:v>
                  </c:pt>
                  <c:pt idx="3">
                    <c:v>It helps to treat the cancer I have</c:v>
                  </c:pt>
                  <c:pt idx="6">
                    <c:v> It helps to diagnose and treat cancers my family has</c:v>
                  </c:pt>
                  <c:pt idx="9">
                    <c:v>If it detects I have a gene for hereditary cancer, it helps to make a future plan</c:v>
                  </c:pt>
                  <c:pt idx="12">
                    <c:v>Cancer precision medicine will become popular</c:v>
                  </c:pt>
                  <c:pt idx="15">
                    <c:v>Registering individual test results in the database helps to enhance the accuracy of the test</c:v>
                  </c:pt>
                </c:lvl>
              </c:multiLvlStrCache>
            </c:multiLvlStrRef>
          </c:cat>
          <c:val>
            <c:numRef>
              <c:f>'benefit_p (color)'!$O$159:$O$176</c:f>
              <c:numCache>
                <c:formatCode>General</c:formatCode>
                <c:ptCount val="18"/>
                <c:pt idx="0" formatCode="0.0">
                  <c:v>0.9</c:v>
                </c:pt>
                <c:pt idx="2" formatCode="0.0">
                  <c:v>3.2</c:v>
                </c:pt>
                <c:pt idx="3" formatCode="0.0">
                  <c:v>1.3</c:v>
                </c:pt>
                <c:pt idx="4" formatCode="0.0">
                  <c:v>1</c:v>
                </c:pt>
                <c:pt idx="5" formatCode="0.0">
                  <c:v>2.8</c:v>
                </c:pt>
                <c:pt idx="6" formatCode="0.0">
                  <c:v>4.0999999999999996</c:v>
                </c:pt>
                <c:pt idx="7" formatCode="0.0">
                  <c:v>0.5</c:v>
                </c:pt>
                <c:pt idx="8" formatCode="0.0">
                  <c:v>2.4</c:v>
                </c:pt>
                <c:pt idx="9" formatCode="0.0">
                  <c:v>0.6</c:v>
                </c:pt>
                <c:pt idx="10" formatCode="0.0">
                  <c:v>0.5</c:v>
                </c:pt>
                <c:pt idx="11" formatCode="0.0">
                  <c:v>1.9</c:v>
                </c:pt>
                <c:pt idx="12" formatCode="0.0">
                  <c:v>0.6</c:v>
                </c:pt>
                <c:pt idx="14" formatCode="0.0">
                  <c:v>1.3</c:v>
                </c:pt>
                <c:pt idx="17" formatCode="0.0">
                  <c:v>1.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9-BC14-4CAA-95BA-6B7CA6552C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10"/>
        <c:overlap val="100"/>
        <c:axId val="40595456"/>
        <c:axId val="39368320"/>
      </c:barChart>
      <c:catAx>
        <c:axId val="40595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368320"/>
        <c:crosses val="autoZero"/>
        <c:auto val="1"/>
        <c:lblAlgn val="ctr"/>
        <c:lblOffset val="100"/>
        <c:noMultiLvlLbl val="0"/>
      </c:catAx>
      <c:valAx>
        <c:axId val="393683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05954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/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le, 50-69years old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CPs=224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FMs=216, GAs=694)</a:t>
            </a:r>
            <a:endParaRPr 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0162911111111111"/>
          <c:y val="3.0115176151761517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benefit_p (color)'!$K$67</c:f>
              <c:strCache>
                <c:ptCount val="1"/>
                <c:pt idx="0">
                  <c:v>Agree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benefit_p (color)'!$I$68:$J$85</c:f>
              <c:multiLvlStrCache>
                <c:ptCount val="18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  <c:pt idx="15">
                    <c:v>CPs</c:v>
                  </c:pt>
                  <c:pt idx="16">
                    <c:v>FMs</c:v>
                  </c:pt>
                  <c:pt idx="17">
                    <c:v>GAs</c:v>
                  </c:pt>
                </c:lvl>
                <c:lvl>
                  <c:pt idx="0">
                    <c:v>It helps to diagnose the type of cancer I have</c:v>
                  </c:pt>
                  <c:pt idx="3">
                    <c:v>It helps to treat the cancer I have</c:v>
                  </c:pt>
                  <c:pt idx="6">
                    <c:v> It helps to diagnose and treat cancers my family has</c:v>
                  </c:pt>
                  <c:pt idx="9">
                    <c:v>If it detects I have a gene for hereditary cancer, it helps to make a future plan</c:v>
                  </c:pt>
                  <c:pt idx="12">
                    <c:v>Cancer precision medicine will become popular</c:v>
                  </c:pt>
                  <c:pt idx="15">
                    <c:v>Registering individual test results in the database helps to enhance the accuracy of the test</c:v>
                  </c:pt>
                </c:lvl>
              </c:multiLvlStrCache>
            </c:multiLvlStrRef>
          </c:cat>
          <c:val>
            <c:numRef>
              <c:f>'benefit_p (color)'!$K$68:$K$85</c:f>
              <c:numCache>
                <c:formatCode>0.0</c:formatCode>
                <c:ptCount val="18"/>
                <c:pt idx="0">
                  <c:v>8.9</c:v>
                </c:pt>
                <c:pt idx="1">
                  <c:v>14.7</c:v>
                </c:pt>
                <c:pt idx="2">
                  <c:v>9.1999999999999993</c:v>
                </c:pt>
                <c:pt idx="3">
                  <c:v>9.4</c:v>
                </c:pt>
                <c:pt idx="4">
                  <c:v>17.5</c:v>
                </c:pt>
                <c:pt idx="5">
                  <c:v>9.9</c:v>
                </c:pt>
                <c:pt idx="6">
                  <c:v>6.3</c:v>
                </c:pt>
                <c:pt idx="7">
                  <c:v>18.899999999999999</c:v>
                </c:pt>
                <c:pt idx="8">
                  <c:v>9.6999999999999993</c:v>
                </c:pt>
                <c:pt idx="9">
                  <c:v>23.5</c:v>
                </c:pt>
                <c:pt idx="10">
                  <c:v>23.5</c:v>
                </c:pt>
                <c:pt idx="11">
                  <c:v>23.5</c:v>
                </c:pt>
                <c:pt idx="12">
                  <c:v>14.3</c:v>
                </c:pt>
                <c:pt idx="13">
                  <c:v>23</c:v>
                </c:pt>
                <c:pt idx="14">
                  <c:v>13</c:v>
                </c:pt>
                <c:pt idx="15">
                  <c:v>15.6</c:v>
                </c:pt>
                <c:pt idx="16">
                  <c:v>24.9</c:v>
                </c:pt>
                <c:pt idx="17">
                  <c:v>1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FEC-4972-A061-800EE4C4CA38}"/>
            </c:ext>
          </c:extLst>
        </c:ser>
        <c:ser>
          <c:idx val="1"/>
          <c:order val="1"/>
          <c:tx>
            <c:strRef>
              <c:f>'benefit_p (color)'!$L$67</c:f>
              <c:strCache>
                <c:ptCount val="1"/>
                <c:pt idx="0">
                  <c:v>Somewhat agree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benefit_p (color)'!$I$68:$J$85</c:f>
              <c:multiLvlStrCache>
                <c:ptCount val="18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  <c:pt idx="15">
                    <c:v>CPs</c:v>
                  </c:pt>
                  <c:pt idx="16">
                    <c:v>FMs</c:v>
                  </c:pt>
                  <c:pt idx="17">
                    <c:v>GAs</c:v>
                  </c:pt>
                </c:lvl>
                <c:lvl>
                  <c:pt idx="0">
                    <c:v>It helps to diagnose the type of cancer I have</c:v>
                  </c:pt>
                  <c:pt idx="3">
                    <c:v>It helps to treat the cancer I have</c:v>
                  </c:pt>
                  <c:pt idx="6">
                    <c:v> It helps to diagnose and treat cancers my family has</c:v>
                  </c:pt>
                  <c:pt idx="9">
                    <c:v>If it detects I have a gene for hereditary cancer, it helps to make a future plan</c:v>
                  </c:pt>
                  <c:pt idx="12">
                    <c:v>Cancer precision medicine will become popular</c:v>
                  </c:pt>
                  <c:pt idx="15">
                    <c:v>Registering individual test results in the database helps to enhance the accuracy of the test</c:v>
                  </c:pt>
                </c:lvl>
              </c:multiLvlStrCache>
            </c:multiLvlStrRef>
          </c:cat>
          <c:val>
            <c:numRef>
              <c:f>'benefit_p (color)'!$L$68:$L$85</c:f>
              <c:numCache>
                <c:formatCode>0.0</c:formatCode>
                <c:ptCount val="18"/>
                <c:pt idx="0">
                  <c:v>40.6</c:v>
                </c:pt>
                <c:pt idx="1">
                  <c:v>55.3</c:v>
                </c:pt>
                <c:pt idx="2">
                  <c:v>40.299999999999997</c:v>
                </c:pt>
                <c:pt idx="3">
                  <c:v>39.299999999999997</c:v>
                </c:pt>
                <c:pt idx="4">
                  <c:v>53.5</c:v>
                </c:pt>
                <c:pt idx="5">
                  <c:v>41.2</c:v>
                </c:pt>
                <c:pt idx="6">
                  <c:v>34.799999999999997</c:v>
                </c:pt>
                <c:pt idx="7">
                  <c:v>55.8</c:v>
                </c:pt>
                <c:pt idx="8">
                  <c:v>43.1</c:v>
                </c:pt>
                <c:pt idx="9">
                  <c:v>38.200000000000003</c:v>
                </c:pt>
                <c:pt idx="10">
                  <c:v>49.3</c:v>
                </c:pt>
                <c:pt idx="11">
                  <c:v>37.700000000000003</c:v>
                </c:pt>
                <c:pt idx="12">
                  <c:v>56.7</c:v>
                </c:pt>
                <c:pt idx="13">
                  <c:v>63.1</c:v>
                </c:pt>
                <c:pt idx="14">
                  <c:v>43.9</c:v>
                </c:pt>
                <c:pt idx="15">
                  <c:v>53.1</c:v>
                </c:pt>
                <c:pt idx="16">
                  <c:v>53.5</c:v>
                </c:pt>
                <c:pt idx="17">
                  <c:v>43.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FEC-4972-A061-800EE4C4CA38}"/>
            </c:ext>
          </c:extLst>
        </c:ser>
        <c:ser>
          <c:idx val="2"/>
          <c:order val="2"/>
          <c:tx>
            <c:strRef>
              <c:f>'benefit_p (color)'!$M$67</c:f>
              <c:strCache>
                <c:ptCount val="1"/>
                <c:pt idx="0">
                  <c:v>Neither agree nor disagree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benefit_p (color)'!$I$68:$J$85</c:f>
              <c:multiLvlStrCache>
                <c:ptCount val="18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  <c:pt idx="15">
                    <c:v>CPs</c:v>
                  </c:pt>
                  <c:pt idx="16">
                    <c:v>FMs</c:v>
                  </c:pt>
                  <c:pt idx="17">
                    <c:v>GAs</c:v>
                  </c:pt>
                </c:lvl>
                <c:lvl>
                  <c:pt idx="0">
                    <c:v>It helps to diagnose the type of cancer I have</c:v>
                  </c:pt>
                  <c:pt idx="3">
                    <c:v>It helps to treat the cancer I have</c:v>
                  </c:pt>
                  <c:pt idx="6">
                    <c:v> It helps to diagnose and treat cancers my family has</c:v>
                  </c:pt>
                  <c:pt idx="9">
                    <c:v>If it detects I have a gene for hereditary cancer, it helps to make a future plan</c:v>
                  </c:pt>
                  <c:pt idx="12">
                    <c:v>Cancer precision medicine will become popular</c:v>
                  </c:pt>
                  <c:pt idx="15">
                    <c:v>Registering individual test results in the database helps to enhance the accuracy of the test</c:v>
                  </c:pt>
                </c:lvl>
              </c:multiLvlStrCache>
            </c:multiLvlStrRef>
          </c:cat>
          <c:val>
            <c:numRef>
              <c:f>'benefit_p (color)'!$M$68:$M$85</c:f>
              <c:numCache>
                <c:formatCode>0.0</c:formatCode>
                <c:ptCount val="18"/>
                <c:pt idx="0">
                  <c:v>44.6</c:v>
                </c:pt>
                <c:pt idx="1">
                  <c:v>25.8</c:v>
                </c:pt>
                <c:pt idx="2">
                  <c:v>42.5</c:v>
                </c:pt>
                <c:pt idx="3">
                  <c:v>43.3</c:v>
                </c:pt>
                <c:pt idx="4">
                  <c:v>22.6</c:v>
                </c:pt>
                <c:pt idx="5">
                  <c:v>40.9</c:v>
                </c:pt>
                <c:pt idx="6">
                  <c:v>53.1</c:v>
                </c:pt>
                <c:pt idx="7">
                  <c:v>20.3</c:v>
                </c:pt>
                <c:pt idx="8">
                  <c:v>40.6</c:v>
                </c:pt>
                <c:pt idx="9">
                  <c:v>41.2</c:v>
                </c:pt>
                <c:pt idx="10">
                  <c:v>25</c:v>
                </c:pt>
                <c:pt idx="11">
                  <c:v>43.2</c:v>
                </c:pt>
                <c:pt idx="12">
                  <c:v>27.7</c:v>
                </c:pt>
                <c:pt idx="13">
                  <c:v>12.4</c:v>
                </c:pt>
                <c:pt idx="14">
                  <c:v>36.6</c:v>
                </c:pt>
                <c:pt idx="15">
                  <c:v>29.5</c:v>
                </c:pt>
                <c:pt idx="16">
                  <c:v>19.8</c:v>
                </c:pt>
                <c:pt idx="17">
                  <c:v>39.20000000000000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DFEC-4972-A061-800EE4C4CA38}"/>
            </c:ext>
          </c:extLst>
        </c:ser>
        <c:ser>
          <c:idx val="3"/>
          <c:order val="3"/>
          <c:tx>
            <c:strRef>
              <c:f>'benefit_p (color)'!$N$67</c:f>
              <c:strCache>
                <c:ptCount val="1"/>
                <c:pt idx="0">
                  <c:v>Somewhat disagree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benefit_p (color)'!$I$68:$J$85</c:f>
              <c:multiLvlStrCache>
                <c:ptCount val="18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  <c:pt idx="15">
                    <c:v>CPs</c:v>
                  </c:pt>
                  <c:pt idx="16">
                    <c:v>FMs</c:v>
                  </c:pt>
                  <c:pt idx="17">
                    <c:v>GAs</c:v>
                  </c:pt>
                </c:lvl>
                <c:lvl>
                  <c:pt idx="0">
                    <c:v>It helps to diagnose the type of cancer I have</c:v>
                  </c:pt>
                  <c:pt idx="3">
                    <c:v>It helps to treat the cancer I have</c:v>
                  </c:pt>
                  <c:pt idx="6">
                    <c:v> It helps to diagnose and treat cancers my family has</c:v>
                  </c:pt>
                  <c:pt idx="9">
                    <c:v>If it detects I have a gene for hereditary cancer, it helps to make a future plan</c:v>
                  </c:pt>
                  <c:pt idx="12">
                    <c:v>Cancer precision medicine will become popular</c:v>
                  </c:pt>
                  <c:pt idx="15">
                    <c:v>Registering individual test results in the database helps to enhance the accuracy of the test</c:v>
                  </c:pt>
                </c:lvl>
              </c:multiLvlStrCache>
            </c:multiLvlStrRef>
          </c:cat>
          <c:val>
            <c:numRef>
              <c:f>'benefit_p (color)'!$N$68:$N$85</c:f>
              <c:numCache>
                <c:formatCode>0.0</c:formatCode>
                <c:ptCount val="18"/>
                <c:pt idx="0">
                  <c:v>3.6</c:v>
                </c:pt>
                <c:pt idx="1">
                  <c:v>1.8</c:v>
                </c:pt>
                <c:pt idx="2">
                  <c:v>3.7</c:v>
                </c:pt>
                <c:pt idx="3">
                  <c:v>5.8</c:v>
                </c:pt>
                <c:pt idx="4">
                  <c:v>3.7</c:v>
                </c:pt>
                <c:pt idx="5">
                  <c:v>3.5</c:v>
                </c:pt>
                <c:pt idx="6">
                  <c:v>3.6</c:v>
                </c:pt>
                <c:pt idx="7">
                  <c:v>3.2</c:v>
                </c:pt>
                <c:pt idx="8">
                  <c:v>2.6</c:v>
                </c:pt>
                <c:pt idx="9">
                  <c:v>2.9</c:v>
                </c:pt>
                <c:pt idx="10">
                  <c:v>1.5</c:v>
                </c:pt>
                <c:pt idx="11">
                  <c:v>4.9000000000000004</c:v>
                </c:pt>
                <c:pt idx="12">
                  <c:v>0.9</c:v>
                </c:pt>
                <c:pt idx="13">
                  <c:v>0.9</c:v>
                </c:pt>
                <c:pt idx="14">
                  <c:v>3.5</c:v>
                </c:pt>
                <c:pt idx="15">
                  <c:v>0.9</c:v>
                </c:pt>
                <c:pt idx="16">
                  <c:v>0.9</c:v>
                </c:pt>
                <c:pt idx="17">
                  <c:v>2.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DFEC-4972-A061-800EE4C4CA38}"/>
            </c:ext>
          </c:extLst>
        </c:ser>
        <c:ser>
          <c:idx val="4"/>
          <c:order val="4"/>
          <c:tx>
            <c:strRef>
              <c:f>'benefit_p (color)'!$O$67</c:f>
              <c:strCache>
                <c:ptCount val="1"/>
                <c:pt idx="0">
                  <c:v>Disagre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multiLvlStrRef>
              <c:f>'benefit_p (color)'!$I$68:$J$85</c:f>
              <c:multiLvlStrCache>
                <c:ptCount val="18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  <c:pt idx="15">
                    <c:v>CPs</c:v>
                  </c:pt>
                  <c:pt idx="16">
                    <c:v>FMs</c:v>
                  </c:pt>
                  <c:pt idx="17">
                    <c:v>GAs</c:v>
                  </c:pt>
                </c:lvl>
                <c:lvl>
                  <c:pt idx="0">
                    <c:v>It helps to diagnose the type of cancer I have</c:v>
                  </c:pt>
                  <c:pt idx="3">
                    <c:v>It helps to treat the cancer I have</c:v>
                  </c:pt>
                  <c:pt idx="6">
                    <c:v> It helps to diagnose and treat cancers my family has</c:v>
                  </c:pt>
                  <c:pt idx="9">
                    <c:v>If it detects I have a gene for hereditary cancer, it helps to make a future plan</c:v>
                  </c:pt>
                  <c:pt idx="12">
                    <c:v>Cancer precision medicine will become popular</c:v>
                  </c:pt>
                  <c:pt idx="15">
                    <c:v>Registering individual test results in the database helps to enhance the accuracy of the test</c:v>
                  </c:pt>
                </c:lvl>
              </c:multiLvlStrCache>
            </c:multiLvlStrRef>
          </c:cat>
          <c:val>
            <c:numRef>
              <c:f>'benefit_p (color)'!$O$68:$O$85</c:f>
              <c:numCache>
                <c:formatCode>0.0</c:formatCode>
                <c:ptCount val="18"/>
                <c:pt idx="0">
                  <c:v>2.2000000000000002</c:v>
                </c:pt>
                <c:pt idx="1">
                  <c:v>2.2999999999999998</c:v>
                </c:pt>
                <c:pt idx="2">
                  <c:v>4.2</c:v>
                </c:pt>
                <c:pt idx="3">
                  <c:v>2.2000000000000002</c:v>
                </c:pt>
                <c:pt idx="4">
                  <c:v>2.8</c:v>
                </c:pt>
                <c:pt idx="5">
                  <c:v>4.5</c:v>
                </c:pt>
                <c:pt idx="6">
                  <c:v>2.2000000000000002</c:v>
                </c:pt>
                <c:pt idx="7">
                  <c:v>1.8</c:v>
                </c:pt>
                <c:pt idx="8">
                  <c:v>4</c:v>
                </c:pt>
                <c:pt idx="10">
                  <c:v>0.7</c:v>
                </c:pt>
                <c:pt idx="11">
                  <c:v>2.5</c:v>
                </c:pt>
                <c:pt idx="12">
                  <c:v>0.4</c:v>
                </c:pt>
                <c:pt idx="13">
                  <c:v>0.5</c:v>
                </c:pt>
                <c:pt idx="14">
                  <c:v>3</c:v>
                </c:pt>
                <c:pt idx="15">
                  <c:v>0.9</c:v>
                </c:pt>
                <c:pt idx="16">
                  <c:v>0.9</c:v>
                </c:pt>
                <c:pt idx="17">
                  <c:v>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9-DFEC-4972-A061-800EE4C4CA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10"/>
        <c:overlap val="100"/>
        <c:axId val="40596480"/>
        <c:axId val="39370048"/>
      </c:barChart>
      <c:catAx>
        <c:axId val="40596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370048"/>
        <c:crosses val="autoZero"/>
        <c:auto val="1"/>
        <c:lblAlgn val="ctr"/>
        <c:lblOffset val="100"/>
        <c:noMultiLvlLbl val="0"/>
      </c:catAx>
      <c:valAx>
        <c:axId val="393700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Narrow" panose="020B060602020203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05964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Arial Narrow" panose="020B060602020203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ale, 20-49years old (CPs=34, FMs=136, GAs=1,420)</a:t>
            </a:r>
          </a:p>
        </c:rich>
      </c:tx>
      <c:layout>
        <c:manualLayout>
          <c:xMode val="edge"/>
          <c:yMode val="edge"/>
          <c:x val="0.11197777777777779"/>
          <c:y val="1.2667344173441734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8.9763555555555555E-2"/>
          <c:y val="0.11273848238482383"/>
          <c:w val="0.87919199999999997"/>
          <c:h val="0.47952913279132792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concern_p (color)'!$C$11</c:f>
              <c:strCache>
                <c:ptCount val="1"/>
                <c:pt idx="0">
                  <c:v>Agree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oncern_p (color)'!$A$12:$B$26</c:f>
              <c:multiLvlStrCache>
                <c:ptCount val="15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</c:lvl>
                <c:lvl>
                  <c:pt idx="0">
                    <c:v>Cost of the test is too expensive for me</c:v>
                  </c:pt>
                  <c:pt idx="3">
                    <c:v>I do not want to know if I have a disease that can be inherited by future generations</c:v>
                  </c:pt>
                  <c:pt idx="6">
                    <c:v>If it detects that I have a gene for hereditary cancer, I worry about the possibility of being treated unfavorably</c:v>
                  </c:pt>
                  <c:pt idx="9">
                    <c:v>Inequalities in access to healthcare by income widen</c:v>
                  </c:pt>
                  <c:pt idx="12">
                    <c:v>I worry about whether the individual test results registered in the database will be used appropriately</c:v>
                  </c:pt>
                </c:lvl>
              </c:multiLvlStrCache>
            </c:multiLvlStrRef>
          </c:cat>
          <c:val>
            <c:numRef>
              <c:f>'concern_p (color)'!$C$12:$C$26</c:f>
              <c:numCache>
                <c:formatCode>0.0</c:formatCode>
                <c:ptCount val="15"/>
                <c:pt idx="0">
                  <c:v>50</c:v>
                </c:pt>
                <c:pt idx="1">
                  <c:v>44.9</c:v>
                </c:pt>
                <c:pt idx="2">
                  <c:v>27.5</c:v>
                </c:pt>
                <c:pt idx="3">
                  <c:v>8.8000000000000007</c:v>
                </c:pt>
                <c:pt idx="4">
                  <c:v>5.9</c:v>
                </c:pt>
                <c:pt idx="5">
                  <c:v>5.3</c:v>
                </c:pt>
                <c:pt idx="7">
                  <c:v>13.2</c:v>
                </c:pt>
                <c:pt idx="8">
                  <c:v>8.9</c:v>
                </c:pt>
                <c:pt idx="9">
                  <c:v>23.5</c:v>
                </c:pt>
                <c:pt idx="10">
                  <c:v>36</c:v>
                </c:pt>
                <c:pt idx="11">
                  <c:v>19.100000000000001</c:v>
                </c:pt>
                <c:pt idx="13">
                  <c:v>16.2</c:v>
                </c:pt>
                <c:pt idx="14">
                  <c:v>12.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C14-4CAA-95BA-6B7CA6552CD2}"/>
            </c:ext>
          </c:extLst>
        </c:ser>
        <c:ser>
          <c:idx val="1"/>
          <c:order val="1"/>
          <c:tx>
            <c:strRef>
              <c:f>'concern_p (color)'!$D$11</c:f>
              <c:strCache>
                <c:ptCount val="1"/>
                <c:pt idx="0">
                  <c:v>Somewhat agree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oncern_p (color)'!$A$12:$B$26</c:f>
              <c:multiLvlStrCache>
                <c:ptCount val="15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</c:lvl>
                <c:lvl>
                  <c:pt idx="0">
                    <c:v>Cost of the test is too expensive for me</c:v>
                  </c:pt>
                  <c:pt idx="3">
                    <c:v>I do not want to know if I have a disease that can be inherited by future generations</c:v>
                  </c:pt>
                  <c:pt idx="6">
                    <c:v>If it detects that I have a gene for hereditary cancer, I worry about the possibility of being treated unfavorably</c:v>
                  </c:pt>
                  <c:pt idx="9">
                    <c:v>Inequalities in access to healthcare by income widen</c:v>
                  </c:pt>
                  <c:pt idx="12">
                    <c:v>I worry about whether the individual test results registered in the database will be used appropriately</c:v>
                  </c:pt>
                </c:lvl>
              </c:multiLvlStrCache>
            </c:multiLvlStrRef>
          </c:cat>
          <c:val>
            <c:numRef>
              <c:f>'concern_p (color)'!$D$12:$D$26</c:f>
              <c:numCache>
                <c:formatCode>0.0</c:formatCode>
                <c:ptCount val="15"/>
                <c:pt idx="0">
                  <c:v>17.600000000000001</c:v>
                </c:pt>
                <c:pt idx="1">
                  <c:v>30.9</c:v>
                </c:pt>
                <c:pt idx="2">
                  <c:v>25.3</c:v>
                </c:pt>
                <c:pt idx="3">
                  <c:v>14.7</c:v>
                </c:pt>
                <c:pt idx="4">
                  <c:v>22.8</c:v>
                </c:pt>
                <c:pt idx="5">
                  <c:v>19.2</c:v>
                </c:pt>
                <c:pt idx="6">
                  <c:v>11.8</c:v>
                </c:pt>
                <c:pt idx="7">
                  <c:v>30.9</c:v>
                </c:pt>
                <c:pt idx="8">
                  <c:v>25.5</c:v>
                </c:pt>
                <c:pt idx="9">
                  <c:v>26.5</c:v>
                </c:pt>
                <c:pt idx="10">
                  <c:v>40.4</c:v>
                </c:pt>
                <c:pt idx="11">
                  <c:v>30.4</c:v>
                </c:pt>
                <c:pt idx="12">
                  <c:v>17.600000000000001</c:v>
                </c:pt>
                <c:pt idx="13">
                  <c:v>34.6</c:v>
                </c:pt>
                <c:pt idx="14">
                  <c:v>27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C14-4CAA-95BA-6B7CA6552CD2}"/>
            </c:ext>
          </c:extLst>
        </c:ser>
        <c:ser>
          <c:idx val="2"/>
          <c:order val="2"/>
          <c:tx>
            <c:strRef>
              <c:f>'concern_p (color)'!$E$11</c:f>
              <c:strCache>
                <c:ptCount val="1"/>
                <c:pt idx="0">
                  <c:v>Neither agree nor disagree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oncern_p (color)'!$A$12:$B$26</c:f>
              <c:multiLvlStrCache>
                <c:ptCount val="15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</c:lvl>
                <c:lvl>
                  <c:pt idx="0">
                    <c:v>Cost of the test is too expensive for me</c:v>
                  </c:pt>
                  <c:pt idx="3">
                    <c:v>I do not want to know if I have a disease that can be inherited by future generations</c:v>
                  </c:pt>
                  <c:pt idx="6">
                    <c:v>If it detects that I have a gene for hereditary cancer, I worry about the possibility of being treated unfavorably</c:v>
                  </c:pt>
                  <c:pt idx="9">
                    <c:v>Inequalities in access to healthcare by income widen</c:v>
                  </c:pt>
                  <c:pt idx="12">
                    <c:v>I worry about whether the individual test results registered in the database will be used appropriately</c:v>
                  </c:pt>
                </c:lvl>
              </c:multiLvlStrCache>
            </c:multiLvlStrRef>
          </c:cat>
          <c:val>
            <c:numRef>
              <c:f>'concern_p (color)'!$E$12:$E$26</c:f>
              <c:numCache>
                <c:formatCode>0.0</c:formatCode>
                <c:ptCount val="15"/>
                <c:pt idx="0">
                  <c:v>29.4</c:v>
                </c:pt>
                <c:pt idx="1">
                  <c:v>22.8</c:v>
                </c:pt>
                <c:pt idx="2">
                  <c:v>40.799999999999997</c:v>
                </c:pt>
                <c:pt idx="3">
                  <c:v>50</c:v>
                </c:pt>
                <c:pt idx="4">
                  <c:v>35.299999999999997</c:v>
                </c:pt>
                <c:pt idx="5">
                  <c:v>52.9</c:v>
                </c:pt>
                <c:pt idx="6">
                  <c:v>61.8</c:v>
                </c:pt>
                <c:pt idx="7">
                  <c:v>35.299999999999997</c:v>
                </c:pt>
                <c:pt idx="8">
                  <c:v>53</c:v>
                </c:pt>
                <c:pt idx="9">
                  <c:v>44.1</c:v>
                </c:pt>
                <c:pt idx="10">
                  <c:v>21.3</c:v>
                </c:pt>
                <c:pt idx="11">
                  <c:v>43.2</c:v>
                </c:pt>
                <c:pt idx="12">
                  <c:v>67.599999999999994</c:v>
                </c:pt>
                <c:pt idx="13">
                  <c:v>39.700000000000003</c:v>
                </c:pt>
                <c:pt idx="14">
                  <c:v>49.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C14-4CAA-95BA-6B7CA6552CD2}"/>
            </c:ext>
          </c:extLst>
        </c:ser>
        <c:ser>
          <c:idx val="3"/>
          <c:order val="3"/>
          <c:tx>
            <c:strRef>
              <c:f>'concern_p (color)'!$F$11</c:f>
              <c:strCache>
                <c:ptCount val="1"/>
                <c:pt idx="0">
                  <c:v>Somewhat disagree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oncern_p (color)'!$A$12:$B$26</c:f>
              <c:multiLvlStrCache>
                <c:ptCount val="15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</c:lvl>
                <c:lvl>
                  <c:pt idx="0">
                    <c:v>Cost of the test is too expensive for me</c:v>
                  </c:pt>
                  <c:pt idx="3">
                    <c:v>I do not want to know if I have a disease that can be inherited by future generations</c:v>
                  </c:pt>
                  <c:pt idx="6">
                    <c:v>If it detects that I have a gene for hereditary cancer, I worry about the possibility of being treated unfavorably</c:v>
                  </c:pt>
                  <c:pt idx="9">
                    <c:v>Inequalities in access to healthcare by income widen</c:v>
                  </c:pt>
                  <c:pt idx="12">
                    <c:v>I worry about whether the individual test results registered in the database will be used appropriately</c:v>
                  </c:pt>
                </c:lvl>
              </c:multiLvlStrCache>
            </c:multiLvlStrRef>
          </c:cat>
          <c:val>
            <c:numRef>
              <c:f>'concern_p (color)'!$F$12:$F$26</c:f>
              <c:numCache>
                <c:formatCode>0.0</c:formatCode>
                <c:ptCount val="15"/>
                <c:pt idx="0">
                  <c:v>2.9</c:v>
                </c:pt>
                <c:pt idx="1">
                  <c:v>1.5</c:v>
                </c:pt>
                <c:pt idx="2">
                  <c:v>4.3</c:v>
                </c:pt>
                <c:pt idx="3">
                  <c:v>17.600000000000001</c:v>
                </c:pt>
                <c:pt idx="4">
                  <c:v>14.7</c:v>
                </c:pt>
                <c:pt idx="5">
                  <c:v>14</c:v>
                </c:pt>
                <c:pt idx="6">
                  <c:v>20.6</c:v>
                </c:pt>
                <c:pt idx="7">
                  <c:v>14</c:v>
                </c:pt>
                <c:pt idx="8">
                  <c:v>8.5</c:v>
                </c:pt>
                <c:pt idx="9">
                  <c:v>5.9</c:v>
                </c:pt>
                <c:pt idx="10">
                  <c:v>1.5</c:v>
                </c:pt>
                <c:pt idx="11">
                  <c:v>5.4</c:v>
                </c:pt>
                <c:pt idx="12">
                  <c:v>11.8</c:v>
                </c:pt>
                <c:pt idx="13">
                  <c:v>6.6</c:v>
                </c:pt>
                <c:pt idx="14">
                  <c:v>8.199999999999999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BC14-4CAA-95BA-6B7CA6552CD2}"/>
            </c:ext>
          </c:extLst>
        </c:ser>
        <c:ser>
          <c:idx val="4"/>
          <c:order val="4"/>
          <c:tx>
            <c:strRef>
              <c:f>'concern_p (color)'!$G$11</c:f>
              <c:strCache>
                <c:ptCount val="1"/>
                <c:pt idx="0">
                  <c:v>Disagre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multiLvlStrRef>
              <c:f>'concern_p (color)'!$A$12:$B$26</c:f>
              <c:multiLvlStrCache>
                <c:ptCount val="15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</c:lvl>
                <c:lvl>
                  <c:pt idx="0">
                    <c:v>Cost of the test is too expensive for me</c:v>
                  </c:pt>
                  <c:pt idx="3">
                    <c:v>I do not want to know if I have a disease that can be inherited by future generations</c:v>
                  </c:pt>
                  <c:pt idx="6">
                    <c:v>If it detects that I have a gene for hereditary cancer, I worry about the possibility of being treated unfavorably</c:v>
                  </c:pt>
                  <c:pt idx="9">
                    <c:v>Inequalities in access to healthcare by income widen</c:v>
                  </c:pt>
                  <c:pt idx="12">
                    <c:v>I worry about whether the individual test results registered in the database will be used appropriately</c:v>
                  </c:pt>
                </c:lvl>
              </c:multiLvlStrCache>
            </c:multiLvlStrRef>
          </c:cat>
          <c:val>
            <c:numRef>
              <c:f>'concern_p (color)'!$G$12:$G$26</c:f>
              <c:numCache>
                <c:formatCode>General</c:formatCode>
                <c:ptCount val="15"/>
                <c:pt idx="2" formatCode="0.0">
                  <c:v>2.1</c:v>
                </c:pt>
                <c:pt idx="3" formatCode="0.0">
                  <c:v>8.8000000000000007</c:v>
                </c:pt>
                <c:pt idx="4" formatCode="0.0">
                  <c:v>21.3</c:v>
                </c:pt>
                <c:pt idx="5" formatCode="0.0">
                  <c:v>8.6</c:v>
                </c:pt>
                <c:pt idx="6" formatCode="0.0">
                  <c:v>5.9</c:v>
                </c:pt>
                <c:pt idx="7" formatCode="0.0">
                  <c:v>6.6</c:v>
                </c:pt>
                <c:pt idx="8" formatCode="0.0">
                  <c:v>4.2</c:v>
                </c:pt>
                <c:pt idx="10" formatCode="0.0">
                  <c:v>0.7</c:v>
                </c:pt>
                <c:pt idx="11" formatCode="0.0">
                  <c:v>1.9</c:v>
                </c:pt>
                <c:pt idx="12" formatCode="0.0">
                  <c:v>2.9</c:v>
                </c:pt>
                <c:pt idx="13" formatCode="0.0">
                  <c:v>2.9</c:v>
                </c:pt>
                <c:pt idx="14" formatCode="0.0">
                  <c:v>2.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9-BC14-4CAA-95BA-6B7CA6552C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10"/>
        <c:overlap val="100"/>
        <c:axId val="40597504"/>
        <c:axId val="78444160"/>
      </c:barChart>
      <c:catAx>
        <c:axId val="40597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8444160"/>
        <c:crosses val="autoZero"/>
        <c:auto val="1"/>
        <c:lblAlgn val="ctr"/>
        <c:lblOffset val="100"/>
        <c:noMultiLvlLbl val="0"/>
      </c:catAx>
      <c:valAx>
        <c:axId val="784441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05975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/>
      </a:pPr>
      <a:endParaRPr lang="ja-JP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ale, 50-69years 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ja-JP" alt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Ps=224, FMs=217, GAs=694)</a:t>
            </a:r>
          </a:p>
        </c:rich>
      </c:tx>
      <c:layout>
        <c:manualLayout>
          <c:xMode val="edge"/>
          <c:yMode val="edge"/>
          <c:x val="0.10872044444444445"/>
          <c:y val="1.0467818428184283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8.9763555555555555E-2"/>
          <c:y val="0.11273848238482385"/>
          <c:w val="0.87919199999999997"/>
          <c:h val="0.47952913279132792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concern_p (color)'!$C$61</c:f>
              <c:strCache>
                <c:ptCount val="1"/>
                <c:pt idx="0">
                  <c:v>Agree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oncern_p (color)'!$A$62:$B$76</c:f>
              <c:multiLvlStrCache>
                <c:ptCount val="15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</c:lvl>
                <c:lvl>
                  <c:pt idx="0">
                    <c:v>Cost of the test is too expensive for me</c:v>
                  </c:pt>
                  <c:pt idx="3">
                    <c:v>I do not want to know if I have a disease that can be inherited by future generations</c:v>
                  </c:pt>
                  <c:pt idx="6">
                    <c:v>If it detects that I have a gene for hereditary cancer, I worry about the possibility of being treated unfavorably</c:v>
                  </c:pt>
                  <c:pt idx="9">
                    <c:v>Inequalities in access to healthcare by income widen</c:v>
                  </c:pt>
                  <c:pt idx="12">
                    <c:v>I worry about whether the individual test results registered in the database will be used appropriately</c:v>
                  </c:pt>
                </c:lvl>
              </c:multiLvlStrCache>
            </c:multiLvlStrRef>
          </c:cat>
          <c:val>
            <c:numRef>
              <c:f>'concern_p (color)'!$C$62:$C$76</c:f>
              <c:numCache>
                <c:formatCode>General</c:formatCode>
                <c:ptCount val="15"/>
                <c:pt idx="0">
                  <c:v>38.799999999999997</c:v>
                </c:pt>
                <c:pt idx="1">
                  <c:v>49.3</c:v>
                </c:pt>
                <c:pt idx="2">
                  <c:v>32.1</c:v>
                </c:pt>
                <c:pt idx="3">
                  <c:v>4.9000000000000004</c:v>
                </c:pt>
                <c:pt idx="4">
                  <c:v>5.5</c:v>
                </c:pt>
                <c:pt idx="5">
                  <c:v>5.6</c:v>
                </c:pt>
                <c:pt idx="6">
                  <c:v>3.1</c:v>
                </c:pt>
                <c:pt idx="7">
                  <c:v>10.1</c:v>
                </c:pt>
                <c:pt idx="8">
                  <c:v>5.9</c:v>
                </c:pt>
                <c:pt idx="9">
                  <c:v>20.5</c:v>
                </c:pt>
                <c:pt idx="10">
                  <c:v>35</c:v>
                </c:pt>
                <c:pt idx="11">
                  <c:v>22</c:v>
                </c:pt>
                <c:pt idx="12">
                  <c:v>11.6</c:v>
                </c:pt>
                <c:pt idx="13">
                  <c:v>16.100000000000001</c:v>
                </c:pt>
                <c:pt idx="14">
                  <c:v>14.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C14-4CAA-95BA-6B7CA6552CD2}"/>
            </c:ext>
          </c:extLst>
        </c:ser>
        <c:ser>
          <c:idx val="1"/>
          <c:order val="1"/>
          <c:tx>
            <c:strRef>
              <c:f>'concern_p (color)'!$D$61</c:f>
              <c:strCache>
                <c:ptCount val="1"/>
                <c:pt idx="0">
                  <c:v>Somewhat agree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oncern_p (color)'!$A$62:$B$76</c:f>
              <c:multiLvlStrCache>
                <c:ptCount val="15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</c:lvl>
                <c:lvl>
                  <c:pt idx="0">
                    <c:v>Cost of the test is too expensive for me</c:v>
                  </c:pt>
                  <c:pt idx="3">
                    <c:v>I do not want to know if I have a disease that can be inherited by future generations</c:v>
                  </c:pt>
                  <c:pt idx="6">
                    <c:v>If it detects that I have a gene for hereditary cancer, I worry about the possibility of being treated unfavorably</c:v>
                  </c:pt>
                  <c:pt idx="9">
                    <c:v>Inequalities in access to healthcare by income widen</c:v>
                  </c:pt>
                  <c:pt idx="12">
                    <c:v>I worry about whether the individual test results registered in the database will be used appropriately</c:v>
                  </c:pt>
                </c:lvl>
              </c:multiLvlStrCache>
            </c:multiLvlStrRef>
          </c:cat>
          <c:val>
            <c:numRef>
              <c:f>'concern_p (color)'!$D$62:$D$76</c:f>
              <c:numCache>
                <c:formatCode>General</c:formatCode>
                <c:ptCount val="15"/>
                <c:pt idx="0">
                  <c:v>28.6</c:v>
                </c:pt>
                <c:pt idx="1">
                  <c:v>27.2</c:v>
                </c:pt>
                <c:pt idx="2">
                  <c:v>27.5</c:v>
                </c:pt>
                <c:pt idx="3">
                  <c:v>12.1</c:v>
                </c:pt>
                <c:pt idx="4">
                  <c:v>17.5</c:v>
                </c:pt>
                <c:pt idx="5">
                  <c:v>17.899999999999999</c:v>
                </c:pt>
                <c:pt idx="6">
                  <c:v>27.2</c:v>
                </c:pt>
                <c:pt idx="7">
                  <c:v>28.1</c:v>
                </c:pt>
                <c:pt idx="8">
                  <c:v>28.8</c:v>
                </c:pt>
                <c:pt idx="9">
                  <c:v>44.2</c:v>
                </c:pt>
                <c:pt idx="10">
                  <c:v>36.9</c:v>
                </c:pt>
                <c:pt idx="11">
                  <c:v>34.4</c:v>
                </c:pt>
                <c:pt idx="12">
                  <c:v>34.4</c:v>
                </c:pt>
                <c:pt idx="13">
                  <c:v>35.9</c:v>
                </c:pt>
                <c:pt idx="14">
                  <c:v>31.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C14-4CAA-95BA-6B7CA6552CD2}"/>
            </c:ext>
          </c:extLst>
        </c:ser>
        <c:ser>
          <c:idx val="2"/>
          <c:order val="2"/>
          <c:tx>
            <c:strRef>
              <c:f>'concern_p (color)'!$E$61</c:f>
              <c:strCache>
                <c:ptCount val="1"/>
                <c:pt idx="0">
                  <c:v>Neither agree nor disagree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oncern_p (color)'!$A$62:$B$76</c:f>
              <c:multiLvlStrCache>
                <c:ptCount val="15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</c:lvl>
                <c:lvl>
                  <c:pt idx="0">
                    <c:v>Cost of the test is too expensive for me</c:v>
                  </c:pt>
                  <c:pt idx="3">
                    <c:v>I do not want to know if I have a disease that can be inherited by future generations</c:v>
                  </c:pt>
                  <c:pt idx="6">
                    <c:v>If it detects that I have a gene for hereditary cancer, I worry about the possibility of being treated unfavorably</c:v>
                  </c:pt>
                  <c:pt idx="9">
                    <c:v>Inequalities in access to healthcare by income widen</c:v>
                  </c:pt>
                  <c:pt idx="12">
                    <c:v>I worry about whether the individual test results registered in the database will be used appropriately</c:v>
                  </c:pt>
                </c:lvl>
              </c:multiLvlStrCache>
            </c:multiLvlStrRef>
          </c:cat>
          <c:val>
            <c:numRef>
              <c:f>'concern_p (color)'!$E$62:$E$76</c:f>
              <c:numCache>
                <c:formatCode>General</c:formatCode>
                <c:ptCount val="15"/>
                <c:pt idx="0">
                  <c:v>29.5</c:v>
                </c:pt>
                <c:pt idx="1">
                  <c:v>20.3</c:v>
                </c:pt>
                <c:pt idx="2">
                  <c:v>35.200000000000003</c:v>
                </c:pt>
                <c:pt idx="3">
                  <c:v>47.3</c:v>
                </c:pt>
                <c:pt idx="4">
                  <c:v>40.1</c:v>
                </c:pt>
                <c:pt idx="5">
                  <c:v>53.5</c:v>
                </c:pt>
                <c:pt idx="6">
                  <c:v>50.9</c:v>
                </c:pt>
                <c:pt idx="7">
                  <c:v>38.700000000000003</c:v>
                </c:pt>
                <c:pt idx="8">
                  <c:v>52.7</c:v>
                </c:pt>
                <c:pt idx="9">
                  <c:v>30.4</c:v>
                </c:pt>
                <c:pt idx="10">
                  <c:v>24.9</c:v>
                </c:pt>
                <c:pt idx="11">
                  <c:v>39</c:v>
                </c:pt>
                <c:pt idx="12">
                  <c:v>42</c:v>
                </c:pt>
                <c:pt idx="13">
                  <c:v>33.200000000000003</c:v>
                </c:pt>
                <c:pt idx="14">
                  <c:v>46.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C14-4CAA-95BA-6B7CA6552CD2}"/>
            </c:ext>
          </c:extLst>
        </c:ser>
        <c:ser>
          <c:idx val="3"/>
          <c:order val="3"/>
          <c:tx>
            <c:strRef>
              <c:f>'concern_p (color)'!$F$61</c:f>
              <c:strCache>
                <c:ptCount val="1"/>
                <c:pt idx="0">
                  <c:v>Somewhat disagree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oncern_p (color)'!$A$62:$B$76</c:f>
              <c:multiLvlStrCache>
                <c:ptCount val="15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</c:lvl>
                <c:lvl>
                  <c:pt idx="0">
                    <c:v>Cost of the test is too expensive for me</c:v>
                  </c:pt>
                  <c:pt idx="3">
                    <c:v>I do not want to know if I have a disease that can be inherited by future generations</c:v>
                  </c:pt>
                  <c:pt idx="6">
                    <c:v>If it detects that I have a gene for hereditary cancer, I worry about the possibility of being treated unfavorably</c:v>
                  </c:pt>
                  <c:pt idx="9">
                    <c:v>Inequalities in access to healthcare by income widen</c:v>
                  </c:pt>
                  <c:pt idx="12">
                    <c:v>I worry about whether the individual test results registered in the database will be used appropriately</c:v>
                  </c:pt>
                </c:lvl>
              </c:multiLvlStrCache>
            </c:multiLvlStrRef>
          </c:cat>
          <c:val>
            <c:numRef>
              <c:f>'concern_p (color)'!$F$62:$F$76</c:f>
              <c:numCache>
                <c:formatCode>General</c:formatCode>
                <c:ptCount val="15"/>
                <c:pt idx="0">
                  <c:v>1.8</c:v>
                </c:pt>
                <c:pt idx="1">
                  <c:v>1.4</c:v>
                </c:pt>
                <c:pt idx="2">
                  <c:v>2.4</c:v>
                </c:pt>
                <c:pt idx="3">
                  <c:v>23.2</c:v>
                </c:pt>
                <c:pt idx="4">
                  <c:v>23.5</c:v>
                </c:pt>
                <c:pt idx="5">
                  <c:v>13.8</c:v>
                </c:pt>
                <c:pt idx="6">
                  <c:v>9.8000000000000007</c:v>
                </c:pt>
                <c:pt idx="7">
                  <c:v>15.2</c:v>
                </c:pt>
                <c:pt idx="8">
                  <c:v>7.6</c:v>
                </c:pt>
                <c:pt idx="9">
                  <c:v>2.7</c:v>
                </c:pt>
                <c:pt idx="10">
                  <c:v>1.8</c:v>
                </c:pt>
                <c:pt idx="11">
                  <c:v>2.2000000000000002</c:v>
                </c:pt>
                <c:pt idx="12">
                  <c:v>8.5</c:v>
                </c:pt>
                <c:pt idx="13">
                  <c:v>12</c:v>
                </c:pt>
                <c:pt idx="14">
                  <c:v>4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BC14-4CAA-95BA-6B7CA6552CD2}"/>
            </c:ext>
          </c:extLst>
        </c:ser>
        <c:ser>
          <c:idx val="4"/>
          <c:order val="4"/>
          <c:tx>
            <c:strRef>
              <c:f>'concern_p (color)'!$G$61</c:f>
              <c:strCache>
                <c:ptCount val="1"/>
                <c:pt idx="0">
                  <c:v>Disagre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multiLvlStrRef>
              <c:f>'concern_p (color)'!$A$62:$B$76</c:f>
              <c:multiLvlStrCache>
                <c:ptCount val="15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</c:lvl>
                <c:lvl>
                  <c:pt idx="0">
                    <c:v>Cost of the test is too expensive for me</c:v>
                  </c:pt>
                  <c:pt idx="3">
                    <c:v>I do not want to know if I have a disease that can be inherited by future generations</c:v>
                  </c:pt>
                  <c:pt idx="6">
                    <c:v>If it detects that I have a gene for hereditary cancer, I worry about the possibility of being treated unfavorably</c:v>
                  </c:pt>
                  <c:pt idx="9">
                    <c:v>Inequalities in access to healthcare by income widen</c:v>
                  </c:pt>
                  <c:pt idx="12">
                    <c:v>I worry about whether the individual test results registered in the database will be used appropriately</c:v>
                  </c:pt>
                </c:lvl>
              </c:multiLvlStrCache>
            </c:multiLvlStrRef>
          </c:cat>
          <c:val>
            <c:numRef>
              <c:f>'concern_p (color)'!$G$62:$G$76</c:f>
              <c:numCache>
                <c:formatCode>General</c:formatCode>
                <c:ptCount val="15"/>
                <c:pt idx="0">
                  <c:v>1.3</c:v>
                </c:pt>
                <c:pt idx="1">
                  <c:v>1.8</c:v>
                </c:pt>
                <c:pt idx="2">
                  <c:v>2.7</c:v>
                </c:pt>
                <c:pt idx="3">
                  <c:v>12.5</c:v>
                </c:pt>
                <c:pt idx="4">
                  <c:v>13.4</c:v>
                </c:pt>
                <c:pt idx="5">
                  <c:v>9.1999999999999993</c:v>
                </c:pt>
                <c:pt idx="6">
                  <c:v>8.9</c:v>
                </c:pt>
                <c:pt idx="7">
                  <c:v>7.8</c:v>
                </c:pt>
                <c:pt idx="8">
                  <c:v>4.9000000000000004</c:v>
                </c:pt>
                <c:pt idx="9">
                  <c:v>2.2000000000000002</c:v>
                </c:pt>
                <c:pt idx="10">
                  <c:v>1.4</c:v>
                </c:pt>
                <c:pt idx="11">
                  <c:v>2.2999999999999998</c:v>
                </c:pt>
                <c:pt idx="12">
                  <c:v>3.6</c:v>
                </c:pt>
                <c:pt idx="13">
                  <c:v>2.8</c:v>
                </c:pt>
                <c:pt idx="14">
                  <c:v>3.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9-BC14-4CAA-95BA-6B7CA6552C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10"/>
        <c:overlap val="100"/>
        <c:axId val="40599040"/>
        <c:axId val="39366016"/>
      </c:barChart>
      <c:catAx>
        <c:axId val="40599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366016"/>
        <c:crosses val="autoZero"/>
        <c:auto val="1"/>
        <c:lblAlgn val="ctr"/>
        <c:lblOffset val="100"/>
        <c:noMultiLvlLbl val="0"/>
      </c:catAx>
      <c:valAx>
        <c:axId val="393660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05990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/>
      </a:pPr>
      <a:endParaRPr lang="ja-JP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Female, 20-49years old (CPs=183, FMs=209, GAs=1,051)</a:t>
            </a:r>
          </a:p>
        </c:rich>
      </c:tx>
      <c:layout>
        <c:manualLayout>
          <c:xMode val="edge"/>
          <c:yMode val="edge"/>
          <c:x val="9.6768469312360689E-2"/>
          <c:y val="1.8975119699608616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8.9763555555555555E-2"/>
          <c:y val="0.11704065040650405"/>
          <c:w val="0.87919199999999997"/>
          <c:h val="0.4752269647696476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concern_p (color)'!$C$107</c:f>
              <c:strCache>
                <c:ptCount val="1"/>
                <c:pt idx="0">
                  <c:v>Agree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oncern_p (color)'!$A$108:$B$122</c:f>
              <c:multiLvlStrCache>
                <c:ptCount val="15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</c:lvl>
                <c:lvl>
                  <c:pt idx="0">
                    <c:v>Cost of the test is too expensive for me</c:v>
                  </c:pt>
                  <c:pt idx="3">
                    <c:v>I do not want to know if I have a disease that can be inherited by future generations</c:v>
                  </c:pt>
                  <c:pt idx="6">
                    <c:v>If it detects that I have a gene for hereditary cancer, I worry about the possibility of being treated unfavorably</c:v>
                  </c:pt>
                  <c:pt idx="9">
                    <c:v>Inequalities in access to healthcare by income widen</c:v>
                  </c:pt>
                  <c:pt idx="12">
                    <c:v>I worry about whether the individual test results registered in the database will be used appropriately</c:v>
                  </c:pt>
                </c:lvl>
              </c:multiLvlStrCache>
            </c:multiLvlStrRef>
          </c:cat>
          <c:val>
            <c:numRef>
              <c:f>'concern_p (color)'!$C$108:$C$122</c:f>
              <c:numCache>
                <c:formatCode>0.0</c:formatCode>
                <c:ptCount val="15"/>
                <c:pt idx="0">
                  <c:v>51.9</c:v>
                </c:pt>
                <c:pt idx="1">
                  <c:v>58.9</c:v>
                </c:pt>
                <c:pt idx="2">
                  <c:v>35.200000000000003</c:v>
                </c:pt>
                <c:pt idx="3">
                  <c:v>7.1</c:v>
                </c:pt>
                <c:pt idx="4">
                  <c:v>7.7</c:v>
                </c:pt>
                <c:pt idx="5">
                  <c:v>5.3</c:v>
                </c:pt>
                <c:pt idx="6">
                  <c:v>10.4</c:v>
                </c:pt>
                <c:pt idx="7">
                  <c:v>8.6</c:v>
                </c:pt>
                <c:pt idx="8">
                  <c:v>7</c:v>
                </c:pt>
                <c:pt idx="9">
                  <c:v>41</c:v>
                </c:pt>
                <c:pt idx="10">
                  <c:v>39.700000000000003</c:v>
                </c:pt>
                <c:pt idx="11">
                  <c:v>24.8</c:v>
                </c:pt>
                <c:pt idx="12">
                  <c:v>18.600000000000001</c:v>
                </c:pt>
                <c:pt idx="13">
                  <c:v>19.600000000000001</c:v>
                </c:pt>
                <c:pt idx="14">
                  <c:v>14.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C14-4CAA-95BA-6B7CA6552CD2}"/>
            </c:ext>
          </c:extLst>
        </c:ser>
        <c:ser>
          <c:idx val="1"/>
          <c:order val="1"/>
          <c:tx>
            <c:strRef>
              <c:f>'concern_p (color)'!$D$107</c:f>
              <c:strCache>
                <c:ptCount val="1"/>
                <c:pt idx="0">
                  <c:v>Somewhat agree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oncern_p (color)'!$A$108:$B$122</c:f>
              <c:multiLvlStrCache>
                <c:ptCount val="15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</c:lvl>
                <c:lvl>
                  <c:pt idx="0">
                    <c:v>Cost of the test is too expensive for me</c:v>
                  </c:pt>
                  <c:pt idx="3">
                    <c:v>I do not want to know if I have a disease that can be inherited by future generations</c:v>
                  </c:pt>
                  <c:pt idx="6">
                    <c:v>If it detects that I have a gene for hereditary cancer, I worry about the possibility of being treated unfavorably</c:v>
                  </c:pt>
                  <c:pt idx="9">
                    <c:v>Inequalities in access to healthcare by income widen</c:v>
                  </c:pt>
                  <c:pt idx="12">
                    <c:v>I worry about whether the individual test results registered in the database will be used appropriately</c:v>
                  </c:pt>
                </c:lvl>
              </c:multiLvlStrCache>
            </c:multiLvlStrRef>
          </c:cat>
          <c:val>
            <c:numRef>
              <c:f>'concern_p (color)'!$D$108:$D$122</c:f>
              <c:numCache>
                <c:formatCode>0.0</c:formatCode>
                <c:ptCount val="15"/>
                <c:pt idx="0">
                  <c:v>30.1</c:v>
                </c:pt>
                <c:pt idx="1">
                  <c:v>27.3</c:v>
                </c:pt>
                <c:pt idx="2">
                  <c:v>28.6</c:v>
                </c:pt>
                <c:pt idx="3">
                  <c:v>16.399999999999999</c:v>
                </c:pt>
                <c:pt idx="4">
                  <c:v>13.4</c:v>
                </c:pt>
                <c:pt idx="5">
                  <c:v>19.399999999999999</c:v>
                </c:pt>
                <c:pt idx="6">
                  <c:v>27.9</c:v>
                </c:pt>
                <c:pt idx="7">
                  <c:v>30.1</c:v>
                </c:pt>
                <c:pt idx="8">
                  <c:v>29.2</c:v>
                </c:pt>
                <c:pt idx="9">
                  <c:v>35.5</c:v>
                </c:pt>
                <c:pt idx="10">
                  <c:v>35.9</c:v>
                </c:pt>
                <c:pt idx="11">
                  <c:v>34.799999999999997</c:v>
                </c:pt>
                <c:pt idx="12">
                  <c:v>39.299999999999997</c:v>
                </c:pt>
                <c:pt idx="13">
                  <c:v>36.799999999999997</c:v>
                </c:pt>
                <c:pt idx="14">
                  <c:v>33.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C14-4CAA-95BA-6B7CA6552CD2}"/>
            </c:ext>
          </c:extLst>
        </c:ser>
        <c:ser>
          <c:idx val="2"/>
          <c:order val="2"/>
          <c:tx>
            <c:strRef>
              <c:f>'concern_p (color)'!$E$107</c:f>
              <c:strCache>
                <c:ptCount val="1"/>
                <c:pt idx="0">
                  <c:v>Neither agree nor disagree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oncern_p (color)'!$A$108:$B$122</c:f>
              <c:multiLvlStrCache>
                <c:ptCount val="15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</c:lvl>
                <c:lvl>
                  <c:pt idx="0">
                    <c:v>Cost of the test is too expensive for me</c:v>
                  </c:pt>
                  <c:pt idx="3">
                    <c:v>I do not want to know if I have a disease that can be inherited by future generations</c:v>
                  </c:pt>
                  <c:pt idx="6">
                    <c:v>If it detects that I have a gene for hereditary cancer, I worry about the possibility of being treated unfavorably</c:v>
                  </c:pt>
                  <c:pt idx="9">
                    <c:v>Inequalities in access to healthcare by income widen</c:v>
                  </c:pt>
                  <c:pt idx="12">
                    <c:v>I worry about whether the individual test results registered in the database will be used appropriately</c:v>
                  </c:pt>
                </c:lvl>
              </c:multiLvlStrCache>
            </c:multiLvlStrRef>
          </c:cat>
          <c:val>
            <c:numRef>
              <c:f>'concern_p (color)'!$E$108:$E$122</c:f>
              <c:numCache>
                <c:formatCode>0.0</c:formatCode>
                <c:ptCount val="15"/>
                <c:pt idx="0">
                  <c:v>16.899999999999999</c:v>
                </c:pt>
                <c:pt idx="1">
                  <c:v>12.9</c:v>
                </c:pt>
                <c:pt idx="2">
                  <c:v>30.6</c:v>
                </c:pt>
                <c:pt idx="3">
                  <c:v>38.299999999999997</c:v>
                </c:pt>
                <c:pt idx="4">
                  <c:v>37.799999999999997</c:v>
                </c:pt>
                <c:pt idx="5">
                  <c:v>45.4</c:v>
                </c:pt>
                <c:pt idx="6">
                  <c:v>39.9</c:v>
                </c:pt>
                <c:pt idx="7">
                  <c:v>34</c:v>
                </c:pt>
                <c:pt idx="8">
                  <c:v>47.4</c:v>
                </c:pt>
                <c:pt idx="9">
                  <c:v>22.4</c:v>
                </c:pt>
                <c:pt idx="10">
                  <c:v>22</c:v>
                </c:pt>
                <c:pt idx="11">
                  <c:v>34.4</c:v>
                </c:pt>
                <c:pt idx="12">
                  <c:v>31.1</c:v>
                </c:pt>
                <c:pt idx="13">
                  <c:v>33</c:v>
                </c:pt>
                <c:pt idx="14">
                  <c:v>41.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C14-4CAA-95BA-6B7CA6552CD2}"/>
            </c:ext>
          </c:extLst>
        </c:ser>
        <c:ser>
          <c:idx val="3"/>
          <c:order val="3"/>
          <c:tx>
            <c:strRef>
              <c:f>'concern_p (color)'!$F$107</c:f>
              <c:strCache>
                <c:ptCount val="1"/>
                <c:pt idx="0">
                  <c:v>Somewhat disagree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oncern_p (color)'!$A$108:$B$122</c:f>
              <c:multiLvlStrCache>
                <c:ptCount val="15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</c:lvl>
                <c:lvl>
                  <c:pt idx="0">
                    <c:v>Cost of the test is too expensive for me</c:v>
                  </c:pt>
                  <c:pt idx="3">
                    <c:v>I do not want to know if I have a disease that can be inherited by future generations</c:v>
                  </c:pt>
                  <c:pt idx="6">
                    <c:v>If it detects that I have a gene for hereditary cancer, I worry about the possibility of being treated unfavorably</c:v>
                  </c:pt>
                  <c:pt idx="9">
                    <c:v>Inequalities in access to healthcare by income widen</c:v>
                  </c:pt>
                  <c:pt idx="12">
                    <c:v>I worry about whether the individual test results registered in the database will be used appropriately</c:v>
                  </c:pt>
                </c:lvl>
              </c:multiLvlStrCache>
            </c:multiLvlStrRef>
          </c:cat>
          <c:val>
            <c:numRef>
              <c:f>'concern_p (color)'!$F$108:$F$122</c:f>
              <c:numCache>
                <c:formatCode>0.0</c:formatCode>
                <c:ptCount val="15"/>
                <c:pt idx="0">
                  <c:v>0.5</c:v>
                </c:pt>
                <c:pt idx="1">
                  <c:v>0.5</c:v>
                </c:pt>
                <c:pt idx="2">
                  <c:v>3.3</c:v>
                </c:pt>
                <c:pt idx="3">
                  <c:v>22.4</c:v>
                </c:pt>
                <c:pt idx="4">
                  <c:v>20.100000000000001</c:v>
                </c:pt>
                <c:pt idx="5">
                  <c:v>18.7</c:v>
                </c:pt>
                <c:pt idx="6">
                  <c:v>10.9</c:v>
                </c:pt>
                <c:pt idx="7">
                  <c:v>17.2</c:v>
                </c:pt>
                <c:pt idx="8">
                  <c:v>12.1</c:v>
                </c:pt>
                <c:pt idx="9">
                  <c:v>0.5</c:v>
                </c:pt>
                <c:pt idx="10">
                  <c:v>1</c:v>
                </c:pt>
                <c:pt idx="11">
                  <c:v>4.0999999999999996</c:v>
                </c:pt>
                <c:pt idx="12">
                  <c:v>7.7</c:v>
                </c:pt>
                <c:pt idx="13">
                  <c:v>6.7</c:v>
                </c:pt>
                <c:pt idx="14">
                  <c:v>7.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BC14-4CAA-95BA-6B7CA6552CD2}"/>
            </c:ext>
          </c:extLst>
        </c:ser>
        <c:ser>
          <c:idx val="4"/>
          <c:order val="4"/>
          <c:tx>
            <c:strRef>
              <c:f>'concern_p (color)'!$G$107</c:f>
              <c:strCache>
                <c:ptCount val="1"/>
                <c:pt idx="0">
                  <c:v>Disagre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multiLvlStrRef>
              <c:f>'concern_p (color)'!$A$108:$B$122</c:f>
              <c:multiLvlStrCache>
                <c:ptCount val="15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</c:lvl>
                <c:lvl>
                  <c:pt idx="0">
                    <c:v>Cost of the test is too expensive for me</c:v>
                  </c:pt>
                  <c:pt idx="3">
                    <c:v>I do not want to know if I have a disease that can be inherited by future generations</c:v>
                  </c:pt>
                  <c:pt idx="6">
                    <c:v>If it detects that I have a gene for hereditary cancer, I worry about the possibility of being treated unfavorably</c:v>
                  </c:pt>
                  <c:pt idx="9">
                    <c:v>Inequalities in access to healthcare by income widen</c:v>
                  </c:pt>
                  <c:pt idx="12">
                    <c:v>I worry about whether the individual test results registered in the database will be used appropriately</c:v>
                  </c:pt>
                </c:lvl>
              </c:multiLvlStrCache>
            </c:multiLvlStrRef>
          </c:cat>
          <c:val>
            <c:numRef>
              <c:f>'concern_p (color)'!$G$108:$G$122</c:f>
              <c:numCache>
                <c:formatCode>0.0</c:formatCode>
                <c:ptCount val="15"/>
                <c:pt idx="0">
                  <c:v>0.5</c:v>
                </c:pt>
                <c:pt idx="1">
                  <c:v>0.5</c:v>
                </c:pt>
                <c:pt idx="2">
                  <c:v>2.2000000000000002</c:v>
                </c:pt>
                <c:pt idx="3">
                  <c:v>15.8</c:v>
                </c:pt>
                <c:pt idx="4">
                  <c:v>21.1</c:v>
                </c:pt>
                <c:pt idx="5">
                  <c:v>11.1</c:v>
                </c:pt>
                <c:pt idx="6">
                  <c:v>10.9</c:v>
                </c:pt>
                <c:pt idx="7">
                  <c:v>10</c:v>
                </c:pt>
                <c:pt idx="8">
                  <c:v>4.3</c:v>
                </c:pt>
                <c:pt idx="9">
                  <c:v>0.5</c:v>
                </c:pt>
                <c:pt idx="10">
                  <c:v>1.4</c:v>
                </c:pt>
                <c:pt idx="11">
                  <c:v>1.8</c:v>
                </c:pt>
                <c:pt idx="12">
                  <c:v>3.3</c:v>
                </c:pt>
                <c:pt idx="13">
                  <c:v>3.8</c:v>
                </c:pt>
                <c:pt idx="14">
                  <c:v>3.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9-BC14-4CAA-95BA-6B7CA6552C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10"/>
        <c:overlap val="100"/>
        <c:axId val="42053632"/>
        <c:axId val="78445312"/>
      </c:barChart>
      <c:catAx>
        <c:axId val="420536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8445312"/>
        <c:crosses val="autoZero"/>
        <c:auto val="1"/>
        <c:lblAlgn val="ctr"/>
        <c:lblOffset val="100"/>
        <c:noMultiLvlLbl val="0"/>
      </c:catAx>
      <c:valAx>
        <c:axId val="784453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0536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/>
      </a:pPr>
      <a:endParaRPr lang="ja-JP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, 50-69years old (CPs=316, FMs=201, GAs=532)</a:t>
            </a:r>
          </a:p>
        </c:rich>
      </c:tx>
      <c:layout>
        <c:manualLayout>
          <c:xMode val="edge"/>
          <c:yMode val="edge"/>
          <c:x val="0.10877533333333333"/>
          <c:y val="1.2764227642276423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8.9763555555555555E-2"/>
          <c:y val="0.11273848238482383"/>
          <c:w val="0.87919199999999997"/>
          <c:h val="0.47952913279132792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concern_p (color)'!$C$162</c:f>
              <c:strCache>
                <c:ptCount val="1"/>
                <c:pt idx="0">
                  <c:v>Agree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oncern_p (color)'!$A$163:$B$177</c:f>
              <c:multiLvlStrCache>
                <c:ptCount val="15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</c:lvl>
                <c:lvl>
                  <c:pt idx="0">
                    <c:v>Cost of the test is too expensive for me</c:v>
                  </c:pt>
                  <c:pt idx="3">
                    <c:v>I do not want to know if I have a disease that can be inherited by future generations</c:v>
                  </c:pt>
                  <c:pt idx="6">
                    <c:v>If it detects that I have a gene for hereditary cancer, I worry about the possibility of being treated unfavorably</c:v>
                  </c:pt>
                  <c:pt idx="9">
                    <c:v>Inequalities in access to healthcare by income widen</c:v>
                  </c:pt>
                  <c:pt idx="12">
                    <c:v>I worry about whether the individual test results registered in the database will be used appropriately</c:v>
                  </c:pt>
                </c:lvl>
              </c:multiLvlStrCache>
            </c:multiLvlStrRef>
          </c:cat>
          <c:val>
            <c:numRef>
              <c:f>'concern_p (color)'!$C$163:$C$177</c:f>
              <c:numCache>
                <c:formatCode>0.0</c:formatCode>
                <c:ptCount val="15"/>
                <c:pt idx="0">
                  <c:v>53.5</c:v>
                </c:pt>
                <c:pt idx="1">
                  <c:v>45.3</c:v>
                </c:pt>
                <c:pt idx="2">
                  <c:v>35.5</c:v>
                </c:pt>
                <c:pt idx="3">
                  <c:v>3.2</c:v>
                </c:pt>
                <c:pt idx="4">
                  <c:v>4</c:v>
                </c:pt>
                <c:pt idx="5">
                  <c:v>6.4</c:v>
                </c:pt>
                <c:pt idx="6">
                  <c:v>5.4</c:v>
                </c:pt>
                <c:pt idx="7">
                  <c:v>4</c:v>
                </c:pt>
                <c:pt idx="8">
                  <c:v>8.5</c:v>
                </c:pt>
                <c:pt idx="9">
                  <c:v>33.9</c:v>
                </c:pt>
                <c:pt idx="10">
                  <c:v>26.9</c:v>
                </c:pt>
                <c:pt idx="11">
                  <c:v>25.8</c:v>
                </c:pt>
                <c:pt idx="12">
                  <c:v>15.8</c:v>
                </c:pt>
                <c:pt idx="13">
                  <c:v>18.899999999999999</c:v>
                </c:pt>
                <c:pt idx="14">
                  <c:v>1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C14-4CAA-95BA-6B7CA6552CD2}"/>
            </c:ext>
          </c:extLst>
        </c:ser>
        <c:ser>
          <c:idx val="1"/>
          <c:order val="1"/>
          <c:tx>
            <c:strRef>
              <c:f>'concern_p (color)'!$D$162</c:f>
              <c:strCache>
                <c:ptCount val="1"/>
                <c:pt idx="0">
                  <c:v>Somewhat agree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oncern_p (color)'!$A$163:$B$177</c:f>
              <c:multiLvlStrCache>
                <c:ptCount val="15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</c:lvl>
                <c:lvl>
                  <c:pt idx="0">
                    <c:v>Cost of the test is too expensive for me</c:v>
                  </c:pt>
                  <c:pt idx="3">
                    <c:v>I do not want to know if I have a disease that can be inherited by future generations</c:v>
                  </c:pt>
                  <c:pt idx="6">
                    <c:v>If it detects that I have a gene for hereditary cancer, I worry about the possibility of being treated unfavorably</c:v>
                  </c:pt>
                  <c:pt idx="9">
                    <c:v>Inequalities in access to healthcare by income widen</c:v>
                  </c:pt>
                  <c:pt idx="12">
                    <c:v>I worry about whether the individual test results registered in the database will be used appropriately</c:v>
                  </c:pt>
                </c:lvl>
              </c:multiLvlStrCache>
            </c:multiLvlStrRef>
          </c:cat>
          <c:val>
            <c:numRef>
              <c:f>'concern_p (color)'!$D$163:$D$177</c:f>
              <c:numCache>
                <c:formatCode>0.0</c:formatCode>
                <c:ptCount val="15"/>
                <c:pt idx="0">
                  <c:v>27.5</c:v>
                </c:pt>
                <c:pt idx="1">
                  <c:v>31.3</c:v>
                </c:pt>
                <c:pt idx="2">
                  <c:v>31.4</c:v>
                </c:pt>
                <c:pt idx="3">
                  <c:v>14.6</c:v>
                </c:pt>
                <c:pt idx="4">
                  <c:v>15.4</c:v>
                </c:pt>
                <c:pt idx="5">
                  <c:v>17.899999999999999</c:v>
                </c:pt>
                <c:pt idx="6">
                  <c:v>26.6</c:v>
                </c:pt>
                <c:pt idx="7">
                  <c:v>26.4</c:v>
                </c:pt>
                <c:pt idx="8">
                  <c:v>29.5</c:v>
                </c:pt>
                <c:pt idx="9">
                  <c:v>45.9</c:v>
                </c:pt>
                <c:pt idx="10">
                  <c:v>46.3</c:v>
                </c:pt>
                <c:pt idx="11">
                  <c:v>38.9</c:v>
                </c:pt>
                <c:pt idx="12">
                  <c:v>39.200000000000003</c:v>
                </c:pt>
                <c:pt idx="13">
                  <c:v>35.299999999999997</c:v>
                </c:pt>
                <c:pt idx="14">
                  <c:v>37.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C14-4CAA-95BA-6B7CA6552CD2}"/>
            </c:ext>
          </c:extLst>
        </c:ser>
        <c:ser>
          <c:idx val="2"/>
          <c:order val="2"/>
          <c:tx>
            <c:strRef>
              <c:f>'concern_p (color)'!$E$162</c:f>
              <c:strCache>
                <c:ptCount val="1"/>
                <c:pt idx="0">
                  <c:v>Neither agree nor disagree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oncern_p (color)'!$A$163:$B$177</c:f>
              <c:multiLvlStrCache>
                <c:ptCount val="15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</c:lvl>
                <c:lvl>
                  <c:pt idx="0">
                    <c:v>Cost of the test is too expensive for me</c:v>
                  </c:pt>
                  <c:pt idx="3">
                    <c:v>I do not want to know if I have a disease that can be inherited by future generations</c:v>
                  </c:pt>
                  <c:pt idx="6">
                    <c:v>If it detects that I have a gene for hereditary cancer, I worry about the possibility of being treated unfavorably</c:v>
                  </c:pt>
                  <c:pt idx="9">
                    <c:v>Inequalities in access to healthcare by income widen</c:v>
                  </c:pt>
                  <c:pt idx="12">
                    <c:v>I worry about whether the individual test results registered in the database will be used appropriately</c:v>
                  </c:pt>
                </c:lvl>
              </c:multiLvlStrCache>
            </c:multiLvlStrRef>
          </c:cat>
          <c:val>
            <c:numRef>
              <c:f>'concern_p (color)'!$E$163:$E$177</c:f>
              <c:numCache>
                <c:formatCode>0.0</c:formatCode>
                <c:ptCount val="15"/>
                <c:pt idx="0">
                  <c:v>16.100000000000001</c:v>
                </c:pt>
                <c:pt idx="1">
                  <c:v>22.4</c:v>
                </c:pt>
                <c:pt idx="2">
                  <c:v>30.1</c:v>
                </c:pt>
                <c:pt idx="3">
                  <c:v>43.7</c:v>
                </c:pt>
                <c:pt idx="4">
                  <c:v>40.299999999999997</c:v>
                </c:pt>
                <c:pt idx="5">
                  <c:v>55.1</c:v>
                </c:pt>
                <c:pt idx="6">
                  <c:v>42.4</c:v>
                </c:pt>
                <c:pt idx="7">
                  <c:v>47.3</c:v>
                </c:pt>
                <c:pt idx="8">
                  <c:v>50.9</c:v>
                </c:pt>
                <c:pt idx="9">
                  <c:v>18.399999999999999</c:v>
                </c:pt>
                <c:pt idx="10">
                  <c:v>24.9</c:v>
                </c:pt>
                <c:pt idx="11">
                  <c:v>33.5</c:v>
                </c:pt>
                <c:pt idx="12">
                  <c:v>31</c:v>
                </c:pt>
                <c:pt idx="13">
                  <c:v>34.299999999999997</c:v>
                </c:pt>
                <c:pt idx="14">
                  <c:v>42.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C14-4CAA-95BA-6B7CA6552CD2}"/>
            </c:ext>
          </c:extLst>
        </c:ser>
        <c:ser>
          <c:idx val="3"/>
          <c:order val="3"/>
          <c:tx>
            <c:strRef>
              <c:f>'concern_p (color)'!$F$162</c:f>
              <c:strCache>
                <c:ptCount val="1"/>
                <c:pt idx="0">
                  <c:v>Somewhat disagree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oncern_p (color)'!$A$163:$B$177</c:f>
              <c:multiLvlStrCache>
                <c:ptCount val="15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</c:lvl>
                <c:lvl>
                  <c:pt idx="0">
                    <c:v>Cost of the test is too expensive for me</c:v>
                  </c:pt>
                  <c:pt idx="3">
                    <c:v>I do not want to know if I have a disease that can be inherited by future generations</c:v>
                  </c:pt>
                  <c:pt idx="6">
                    <c:v>If it detects that I have a gene for hereditary cancer, I worry about the possibility of being treated unfavorably</c:v>
                  </c:pt>
                  <c:pt idx="9">
                    <c:v>Inequalities in access to healthcare by income widen</c:v>
                  </c:pt>
                  <c:pt idx="12">
                    <c:v>I worry about whether the individual test results registered in the database will be used appropriately</c:v>
                  </c:pt>
                </c:lvl>
              </c:multiLvlStrCache>
            </c:multiLvlStrRef>
          </c:cat>
          <c:val>
            <c:numRef>
              <c:f>'concern_p (color)'!$F$163:$F$177</c:f>
              <c:numCache>
                <c:formatCode>0.0</c:formatCode>
                <c:ptCount val="15"/>
                <c:pt idx="0">
                  <c:v>1.9</c:v>
                </c:pt>
                <c:pt idx="1">
                  <c:v>1</c:v>
                </c:pt>
                <c:pt idx="2">
                  <c:v>2.1</c:v>
                </c:pt>
                <c:pt idx="3">
                  <c:v>25</c:v>
                </c:pt>
                <c:pt idx="4">
                  <c:v>28.4</c:v>
                </c:pt>
                <c:pt idx="5">
                  <c:v>15</c:v>
                </c:pt>
                <c:pt idx="6">
                  <c:v>17.399999999999999</c:v>
                </c:pt>
                <c:pt idx="7">
                  <c:v>15.4</c:v>
                </c:pt>
                <c:pt idx="8">
                  <c:v>9.1999999999999993</c:v>
                </c:pt>
                <c:pt idx="9">
                  <c:v>1.9</c:v>
                </c:pt>
                <c:pt idx="10">
                  <c:v>2</c:v>
                </c:pt>
                <c:pt idx="11">
                  <c:v>1.3</c:v>
                </c:pt>
                <c:pt idx="12">
                  <c:v>11.4</c:v>
                </c:pt>
                <c:pt idx="13">
                  <c:v>9.5</c:v>
                </c:pt>
                <c:pt idx="14">
                  <c:v>3.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BC14-4CAA-95BA-6B7CA6552CD2}"/>
            </c:ext>
          </c:extLst>
        </c:ser>
        <c:ser>
          <c:idx val="4"/>
          <c:order val="4"/>
          <c:tx>
            <c:strRef>
              <c:f>'concern_p (color)'!$G$162</c:f>
              <c:strCache>
                <c:ptCount val="1"/>
                <c:pt idx="0">
                  <c:v>Disagre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multiLvlStrRef>
              <c:f>'concern_p (color)'!$A$163:$B$177</c:f>
              <c:multiLvlStrCache>
                <c:ptCount val="15"/>
                <c:lvl>
                  <c:pt idx="0">
                    <c:v>CPs</c:v>
                  </c:pt>
                  <c:pt idx="1">
                    <c:v>FMs</c:v>
                  </c:pt>
                  <c:pt idx="2">
                    <c:v>GAs</c:v>
                  </c:pt>
                  <c:pt idx="3">
                    <c:v>CPs</c:v>
                  </c:pt>
                  <c:pt idx="4">
                    <c:v>FMs</c:v>
                  </c:pt>
                  <c:pt idx="5">
                    <c:v>GAs</c:v>
                  </c:pt>
                  <c:pt idx="6">
                    <c:v>CPs</c:v>
                  </c:pt>
                  <c:pt idx="7">
                    <c:v>FMs</c:v>
                  </c:pt>
                  <c:pt idx="8">
                    <c:v>GAs</c:v>
                  </c:pt>
                  <c:pt idx="9">
                    <c:v>CPs</c:v>
                  </c:pt>
                  <c:pt idx="10">
                    <c:v>FMs</c:v>
                  </c:pt>
                  <c:pt idx="11">
                    <c:v>GAs</c:v>
                  </c:pt>
                  <c:pt idx="12">
                    <c:v>CPs</c:v>
                  </c:pt>
                  <c:pt idx="13">
                    <c:v>FMs</c:v>
                  </c:pt>
                  <c:pt idx="14">
                    <c:v>GAs</c:v>
                  </c:pt>
                </c:lvl>
                <c:lvl>
                  <c:pt idx="0">
                    <c:v>Cost of the test is too expensive for me</c:v>
                  </c:pt>
                  <c:pt idx="3">
                    <c:v>I do not want to know if I have a disease that can be inherited by future generations</c:v>
                  </c:pt>
                  <c:pt idx="6">
                    <c:v>If it detects that I have a gene for hereditary cancer, I worry about the possibility of being treated unfavorably</c:v>
                  </c:pt>
                  <c:pt idx="9">
                    <c:v>Inequalities in access to healthcare by income widen</c:v>
                  </c:pt>
                  <c:pt idx="12">
                    <c:v>I worry about whether the individual test results registered in the database will be used appropriately</c:v>
                  </c:pt>
                </c:lvl>
              </c:multiLvlStrCache>
            </c:multiLvlStrRef>
          </c:cat>
          <c:val>
            <c:numRef>
              <c:f>'concern_p (color)'!$G$163:$G$177</c:f>
              <c:numCache>
                <c:formatCode>General</c:formatCode>
                <c:ptCount val="15"/>
                <c:pt idx="0" formatCode="0.0">
                  <c:v>0.9</c:v>
                </c:pt>
                <c:pt idx="2" formatCode="0.0">
                  <c:v>0.9</c:v>
                </c:pt>
                <c:pt idx="3" formatCode="0.0">
                  <c:v>13.6</c:v>
                </c:pt>
                <c:pt idx="4" formatCode="0.0">
                  <c:v>11.9</c:v>
                </c:pt>
                <c:pt idx="5" formatCode="0.0">
                  <c:v>5.6</c:v>
                </c:pt>
                <c:pt idx="6" formatCode="0.0">
                  <c:v>8.1999999999999993</c:v>
                </c:pt>
                <c:pt idx="7" formatCode="0.0">
                  <c:v>7</c:v>
                </c:pt>
                <c:pt idx="8" formatCode="0.0">
                  <c:v>1.9</c:v>
                </c:pt>
                <c:pt idx="11" formatCode="0.0">
                  <c:v>0.6</c:v>
                </c:pt>
                <c:pt idx="12" formatCode="0.0">
                  <c:v>2.5</c:v>
                </c:pt>
                <c:pt idx="13" formatCode="0.0">
                  <c:v>2</c:v>
                </c:pt>
                <c:pt idx="14" formatCode="0.0">
                  <c:v>0.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9-BC14-4CAA-95BA-6B7CA6552C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10"/>
        <c:overlap val="100"/>
        <c:axId val="42056192"/>
        <c:axId val="42312832"/>
      </c:barChart>
      <c:catAx>
        <c:axId val="420561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2312832"/>
        <c:crosses val="autoZero"/>
        <c:auto val="1"/>
        <c:lblAlgn val="ctr"/>
        <c:lblOffset val="100"/>
        <c:noMultiLvlLbl val="0"/>
      </c:catAx>
      <c:valAx>
        <c:axId val="423128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0561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/>
      </a:pPr>
      <a:endParaRPr lang="ja-JP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colors3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colors6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colors7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colors8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451-EC39-4B0C-BAFF-50ECF84A07BE}" type="datetimeFigureOut">
              <a:rPr kumimoji="1" lang="ja-JP" altLang="en-US" smtClean="0"/>
              <a:t>2018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B9754-BD07-4EE2-B360-C4DB45C0CC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1414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451-EC39-4B0C-BAFF-50ECF84A07BE}" type="datetimeFigureOut">
              <a:rPr kumimoji="1" lang="ja-JP" altLang="en-US" smtClean="0"/>
              <a:t>2018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B9754-BD07-4EE2-B360-C4DB45C0CC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0486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451-EC39-4B0C-BAFF-50ECF84A07BE}" type="datetimeFigureOut">
              <a:rPr kumimoji="1" lang="ja-JP" altLang="en-US" smtClean="0"/>
              <a:t>2018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B9754-BD07-4EE2-B360-C4DB45C0CC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4243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451-EC39-4B0C-BAFF-50ECF84A07BE}" type="datetimeFigureOut">
              <a:rPr kumimoji="1" lang="ja-JP" altLang="en-US" smtClean="0"/>
              <a:t>2018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B9754-BD07-4EE2-B360-C4DB45C0CC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5417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451-EC39-4B0C-BAFF-50ECF84A07BE}" type="datetimeFigureOut">
              <a:rPr kumimoji="1" lang="ja-JP" altLang="en-US" smtClean="0"/>
              <a:t>2018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B9754-BD07-4EE2-B360-C4DB45C0CC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8740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451-EC39-4B0C-BAFF-50ECF84A07BE}" type="datetimeFigureOut">
              <a:rPr kumimoji="1" lang="ja-JP" altLang="en-US" smtClean="0"/>
              <a:t>2018/1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B9754-BD07-4EE2-B360-C4DB45C0CC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3753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451-EC39-4B0C-BAFF-50ECF84A07BE}" type="datetimeFigureOut">
              <a:rPr kumimoji="1" lang="ja-JP" altLang="en-US" smtClean="0"/>
              <a:t>2018/12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B9754-BD07-4EE2-B360-C4DB45C0CC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66685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451-EC39-4B0C-BAFF-50ECF84A07BE}" type="datetimeFigureOut">
              <a:rPr kumimoji="1" lang="ja-JP" altLang="en-US" smtClean="0"/>
              <a:t>2018/12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B9754-BD07-4EE2-B360-C4DB45C0CC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8006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451-EC39-4B0C-BAFF-50ECF84A07BE}" type="datetimeFigureOut">
              <a:rPr kumimoji="1" lang="ja-JP" altLang="en-US" smtClean="0"/>
              <a:t>2018/12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B9754-BD07-4EE2-B360-C4DB45C0CC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66352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451-EC39-4B0C-BAFF-50ECF84A07BE}" type="datetimeFigureOut">
              <a:rPr kumimoji="1" lang="ja-JP" altLang="en-US" smtClean="0"/>
              <a:t>2018/1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B9754-BD07-4EE2-B360-C4DB45C0CC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9136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451-EC39-4B0C-BAFF-50ECF84A07BE}" type="datetimeFigureOut">
              <a:rPr kumimoji="1" lang="ja-JP" altLang="en-US" smtClean="0"/>
              <a:t>2018/1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B9754-BD07-4EE2-B360-C4DB45C0CC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62793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AF3451-EC39-4B0C-BAFF-50ECF84A07BE}" type="datetimeFigureOut">
              <a:rPr kumimoji="1" lang="ja-JP" altLang="en-US" smtClean="0"/>
              <a:t>2018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2B9754-BD07-4EE2-B360-C4DB45C0CC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87576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テキスト ボックス 22"/>
          <p:cNvSpPr txBox="1"/>
          <p:nvPr/>
        </p:nvSpPr>
        <p:spPr>
          <a:xfrm>
            <a:off x="0" y="12155269"/>
            <a:ext cx="960120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CA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CA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1: </a:t>
            </a:r>
            <a:r>
              <a:rPr lang="en-CA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istribution </a:t>
            </a:r>
            <a:r>
              <a:rPr lang="en-CA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of perception of benefits and concerns about GTPTs </a:t>
            </a:r>
            <a:r>
              <a:rPr lang="en-CA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tratified by </a:t>
            </a:r>
            <a:r>
              <a:rPr lang="en-CA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ex and age. </a:t>
            </a:r>
            <a:endParaRPr lang="ja-JP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CA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5-point </a:t>
            </a:r>
            <a:r>
              <a:rPr lang="en-CA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Likert scale was used to measure the respondents’ perception </a:t>
            </a:r>
            <a:r>
              <a:rPr lang="en-CA" altLang="ja-JP" sz="110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CA" altLang="ja-JP" sz="1100" smtClean="0">
                <a:latin typeface="Arial" panose="020B0604020202020204" pitchFamily="34" charset="0"/>
                <a:cs typeface="Arial" panose="020B0604020202020204" pitchFamily="34" charset="0"/>
              </a:rPr>
              <a:t>benefits (a-d) </a:t>
            </a:r>
            <a:r>
              <a:rPr lang="en-CA" altLang="ja-JP" sz="110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CA" altLang="ja-JP" sz="1100" smtClean="0">
                <a:latin typeface="Arial" panose="020B0604020202020204" pitchFamily="34" charset="0"/>
                <a:cs typeface="Arial" panose="020B0604020202020204" pitchFamily="34" charset="0"/>
              </a:rPr>
              <a:t>concerns (e-h) </a:t>
            </a:r>
            <a:r>
              <a:rPr lang="en-CA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about GTPTs. All groups stratified sex and age (50&lt; or 50≥). </a:t>
            </a:r>
            <a:r>
              <a:rPr lang="en-CA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TPTs</a:t>
            </a:r>
            <a:r>
              <a:rPr lang="en-CA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: genomic tumor profiling tests, CPs: cancer patients, FMs: family members of cancer patients, GAs: general </a:t>
            </a:r>
            <a:r>
              <a:rPr lang="en-CA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dults.</a:t>
            </a:r>
            <a:endParaRPr lang="ja-JP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グループ化 23"/>
          <p:cNvGrpSpPr/>
          <p:nvPr/>
        </p:nvGrpSpPr>
        <p:grpSpPr>
          <a:xfrm>
            <a:off x="228600" y="0"/>
            <a:ext cx="9197225" cy="12112662"/>
            <a:chOff x="228600" y="95250"/>
            <a:chExt cx="9197225" cy="12112662"/>
          </a:xfrm>
        </p:grpSpPr>
        <p:sp>
          <p:nvSpPr>
            <p:cNvPr id="39" name="正方形/長方形 38"/>
            <p:cNvSpPr/>
            <p:nvPr/>
          </p:nvSpPr>
          <p:spPr>
            <a:xfrm>
              <a:off x="228600" y="95250"/>
              <a:ext cx="9182100" cy="1209675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" name="グループ化 3"/>
            <p:cNvGrpSpPr/>
            <p:nvPr/>
          </p:nvGrpSpPr>
          <p:grpSpPr>
            <a:xfrm>
              <a:off x="273911" y="130628"/>
              <a:ext cx="4500000" cy="2952000"/>
              <a:chOff x="495979" y="365760"/>
              <a:chExt cx="4500000" cy="2952000"/>
            </a:xfrm>
          </p:grpSpPr>
          <p:graphicFrame>
            <p:nvGraphicFramePr>
              <p:cNvPr id="41" name="グラフ 40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65261241"/>
                  </p:ext>
                </p:extLst>
              </p:nvPr>
            </p:nvGraphicFramePr>
            <p:xfrm>
              <a:off x="495979" y="365760"/>
              <a:ext cx="4500000" cy="2952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3" name="テキスト ボックス 2"/>
              <p:cNvSpPr txBox="1"/>
              <p:nvPr/>
            </p:nvSpPr>
            <p:spPr>
              <a:xfrm>
                <a:off x="495979" y="365760"/>
                <a:ext cx="214853" cy="276999"/>
              </a:xfrm>
              <a:prstGeom prst="rect">
                <a:avLst/>
              </a:prstGeom>
              <a:noFill/>
            </p:spPr>
            <p:txBody>
              <a:bodyPr wrap="none" lIns="72000" tIns="0" rIns="36000" bIns="0" rtlCol="0">
                <a:spAutoFit/>
              </a:bodyPr>
              <a:lstStyle/>
              <a:p>
                <a:r>
                  <a:rPr kumimoji="1" lang="en-US" altLang="ja-JP" dirty="0" smtClean="0">
                    <a:latin typeface="Arial Narrow" panose="020B0606020202030204" pitchFamily="34" charset="0"/>
                    <a:cs typeface="Arial" panose="020B0604020202020204" pitchFamily="34" charset="0"/>
                  </a:rPr>
                  <a:t>a</a:t>
                </a:r>
                <a:endParaRPr kumimoji="1" lang="ja-JP" altLang="en-US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" name="グループ化 6"/>
            <p:cNvGrpSpPr/>
            <p:nvPr/>
          </p:nvGrpSpPr>
          <p:grpSpPr>
            <a:xfrm>
              <a:off x="273911" y="3083140"/>
              <a:ext cx="4500000" cy="2952000"/>
              <a:chOff x="286974" y="3030855"/>
              <a:chExt cx="4500000" cy="2952000"/>
            </a:xfrm>
          </p:grpSpPr>
          <p:graphicFrame>
            <p:nvGraphicFramePr>
              <p:cNvPr id="53" name="グラフ 5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479630248"/>
                  </p:ext>
                </p:extLst>
              </p:nvPr>
            </p:nvGraphicFramePr>
            <p:xfrm>
              <a:off x="286974" y="3030855"/>
              <a:ext cx="4500000" cy="2952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48" name="テキスト ボックス 47"/>
              <p:cNvSpPr txBox="1"/>
              <p:nvPr/>
            </p:nvSpPr>
            <p:spPr>
              <a:xfrm>
                <a:off x="286974" y="3030855"/>
                <a:ext cx="203632" cy="276999"/>
              </a:xfrm>
              <a:prstGeom prst="rect">
                <a:avLst/>
              </a:prstGeom>
              <a:noFill/>
            </p:spPr>
            <p:txBody>
              <a:bodyPr wrap="none" lIns="72000" tIns="0" rIns="36000" bIns="0" rtlCol="0">
                <a:spAutoFit/>
              </a:bodyPr>
              <a:lstStyle/>
              <a:p>
                <a:r>
                  <a:rPr kumimoji="1" lang="en-US" altLang="ja-JP" dirty="0" smtClean="0">
                    <a:latin typeface="Arial Narrow" panose="020B0606020202030204" pitchFamily="34" charset="0"/>
                    <a:cs typeface="Arial" panose="020B0604020202020204" pitchFamily="34" charset="0"/>
                  </a:rPr>
                  <a:t>c</a:t>
                </a:r>
                <a:endParaRPr kumimoji="1" lang="ja-JP" altLang="en-US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" name="グループ化 8"/>
            <p:cNvGrpSpPr/>
            <p:nvPr/>
          </p:nvGrpSpPr>
          <p:grpSpPr>
            <a:xfrm>
              <a:off x="4925825" y="3083140"/>
              <a:ext cx="4500000" cy="2952000"/>
              <a:chOff x="4767535" y="2999831"/>
              <a:chExt cx="4500000" cy="2952000"/>
            </a:xfrm>
          </p:grpSpPr>
          <p:graphicFrame>
            <p:nvGraphicFramePr>
              <p:cNvPr id="54" name="グラフ 5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766118057"/>
                  </p:ext>
                </p:extLst>
              </p:nvPr>
            </p:nvGraphicFramePr>
            <p:xfrm>
              <a:off x="4767535" y="2999831"/>
              <a:ext cx="4500000" cy="2952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49" name="テキスト ボックス 48"/>
              <p:cNvSpPr txBox="1"/>
              <p:nvPr/>
            </p:nvSpPr>
            <p:spPr>
              <a:xfrm>
                <a:off x="4767535" y="2999831"/>
                <a:ext cx="214853" cy="276999"/>
              </a:xfrm>
              <a:prstGeom prst="rect">
                <a:avLst/>
              </a:prstGeom>
              <a:noFill/>
            </p:spPr>
            <p:txBody>
              <a:bodyPr wrap="none" lIns="72000" tIns="0" rIns="36000" bIns="0" rtlCol="0">
                <a:spAutoFit/>
              </a:bodyPr>
              <a:lstStyle/>
              <a:p>
                <a:r>
                  <a:rPr kumimoji="1" lang="en-US" altLang="ja-JP" dirty="0" smtClean="0">
                    <a:latin typeface="Arial Narrow" panose="020B0606020202030204" pitchFamily="34" charset="0"/>
                    <a:cs typeface="Arial" panose="020B0604020202020204" pitchFamily="34" charset="0"/>
                  </a:rPr>
                  <a:t>d</a:t>
                </a:r>
                <a:endParaRPr kumimoji="1" lang="ja-JP" altLang="en-US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" name="グループ化 4"/>
            <p:cNvGrpSpPr/>
            <p:nvPr/>
          </p:nvGrpSpPr>
          <p:grpSpPr>
            <a:xfrm>
              <a:off x="4925825" y="130628"/>
              <a:ext cx="4500000" cy="2952000"/>
              <a:chOff x="4845912" y="128133"/>
              <a:chExt cx="4500000" cy="2952000"/>
            </a:xfrm>
          </p:grpSpPr>
          <p:graphicFrame>
            <p:nvGraphicFramePr>
              <p:cNvPr id="44" name="グラフ 4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71960145"/>
                  </p:ext>
                </p:extLst>
              </p:nvPr>
            </p:nvGraphicFramePr>
            <p:xfrm>
              <a:off x="4845912" y="128133"/>
              <a:ext cx="4500000" cy="2952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52" name="テキスト ボックス 51"/>
              <p:cNvSpPr txBox="1"/>
              <p:nvPr/>
            </p:nvSpPr>
            <p:spPr>
              <a:xfrm>
                <a:off x="4845912" y="128133"/>
                <a:ext cx="214853" cy="276999"/>
              </a:xfrm>
              <a:prstGeom prst="rect">
                <a:avLst/>
              </a:prstGeom>
              <a:noFill/>
            </p:spPr>
            <p:txBody>
              <a:bodyPr wrap="none" lIns="72000" tIns="0" rIns="36000" bIns="0" rtlCol="0">
                <a:spAutoFit/>
              </a:bodyPr>
              <a:lstStyle/>
              <a:p>
                <a:r>
                  <a:rPr kumimoji="1" lang="en-US" altLang="ja-JP" dirty="0" smtClean="0">
                    <a:latin typeface="Arial Narrow" panose="020B0606020202030204" pitchFamily="34" charset="0"/>
                    <a:cs typeface="Arial" panose="020B0604020202020204" pitchFamily="34" charset="0"/>
                  </a:rPr>
                  <a:t>b</a:t>
                </a:r>
                <a:endParaRPr kumimoji="1" lang="ja-JP" altLang="en-US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" name="グループ化 9"/>
            <p:cNvGrpSpPr/>
            <p:nvPr/>
          </p:nvGrpSpPr>
          <p:grpSpPr>
            <a:xfrm>
              <a:off x="273911" y="6035652"/>
              <a:ext cx="4500000" cy="2952000"/>
              <a:chOff x="300037" y="5944008"/>
              <a:chExt cx="4500000" cy="2952000"/>
            </a:xfrm>
          </p:grpSpPr>
          <p:sp>
            <p:nvSpPr>
              <p:cNvPr id="50" name="テキスト ボックス 49"/>
              <p:cNvSpPr txBox="1"/>
              <p:nvPr/>
            </p:nvSpPr>
            <p:spPr>
              <a:xfrm>
                <a:off x="300037" y="5944008"/>
                <a:ext cx="214853" cy="276999"/>
              </a:xfrm>
              <a:prstGeom prst="rect">
                <a:avLst/>
              </a:prstGeom>
              <a:noFill/>
            </p:spPr>
            <p:txBody>
              <a:bodyPr wrap="none" lIns="72000" tIns="0" rIns="36000" bIns="0" rtlCol="0">
                <a:spAutoFit/>
              </a:bodyPr>
              <a:lstStyle/>
              <a:p>
                <a:r>
                  <a:rPr lang="en-US" altLang="ja-JP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e</a:t>
                </a:r>
                <a:endParaRPr kumimoji="1" lang="ja-JP" altLang="en-US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55" name="グラフ 5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950201884"/>
                  </p:ext>
                </p:extLst>
              </p:nvPr>
            </p:nvGraphicFramePr>
            <p:xfrm>
              <a:off x="300037" y="5944008"/>
              <a:ext cx="4500000" cy="2952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</p:grpSp>
        <p:grpSp>
          <p:nvGrpSpPr>
            <p:cNvPr id="11" name="グループ化 10"/>
            <p:cNvGrpSpPr/>
            <p:nvPr/>
          </p:nvGrpSpPr>
          <p:grpSpPr>
            <a:xfrm>
              <a:off x="4925825" y="6035652"/>
              <a:ext cx="4500000" cy="2952000"/>
              <a:chOff x="4898162" y="5849620"/>
              <a:chExt cx="4500000" cy="2952000"/>
            </a:xfrm>
          </p:grpSpPr>
          <p:sp>
            <p:nvSpPr>
              <p:cNvPr id="43" name="テキスト ボックス 42"/>
              <p:cNvSpPr txBox="1"/>
              <p:nvPr/>
            </p:nvSpPr>
            <p:spPr>
              <a:xfrm>
                <a:off x="4898162" y="5849620"/>
                <a:ext cx="161954" cy="276999"/>
              </a:xfrm>
              <a:prstGeom prst="rect">
                <a:avLst/>
              </a:prstGeom>
              <a:noFill/>
            </p:spPr>
            <p:txBody>
              <a:bodyPr wrap="none" lIns="72000" tIns="0" rIns="36000" bIns="0" rtlCol="0">
                <a:spAutoFit/>
              </a:bodyPr>
              <a:lstStyle/>
              <a:p>
                <a:r>
                  <a:rPr kumimoji="1" lang="en-US" altLang="ja-JP" dirty="0" smtClean="0">
                    <a:latin typeface="Arial Narrow" panose="020B0606020202030204" pitchFamily="34" charset="0"/>
                    <a:cs typeface="Arial" panose="020B0604020202020204" pitchFamily="34" charset="0"/>
                  </a:rPr>
                  <a:t>f</a:t>
                </a:r>
                <a:endParaRPr kumimoji="1" lang="ja-JP" altLang="en-US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56" name="グラフ 5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58879005"/>
                  </p:ext>
                </p:extLst>
              </p:nvPr>
            </p:nvGraphicFramePr>
            <p:xfrm>
              <a:off x="4898162" y="5849620"/>
              <a:ext cx="4500000" cy="2952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</p:grpSp>
        <p:grpSp>
          <p:nvGrpSpPr>
            <p:cNvPr id="12" name="グループ化 11"/>
            <p:cNvGrpSpPr/>
            <p:nvPr/>
          </p:nvGrpSpPr>
          <p:grpSpPr>
            <a:xfrm>
              <a:off x="273911" y="8988163"/>
              <a:ext cx="4500000" cy="2952000"/>
              <a:chOff x="286590" y="8988163"/>
              <a:chExt cx="4500000" cy="2952000"/>
            </a:xfrm>
          </p:grpSpPr>
          <p:sp>
            <p:nvSpPr>
              <p:cNvPr id="45" name="テキスト ボックス 44"/>
              <p:cNvSpPr txBox="1"/>
              <p:nvPr/>
            </p:nvSpPr>
            <p:spPr>
              <a:xfrm>
                <a:off x="286590" y="8988163"/>
                <a:ext cx="214853" cy="276999"/>
              </a:xfrm>
              <a:prstGeom prst="rect">
                <a:avLst/>
              </a:prstGeom>
              <a:noFill/>
            </p:spPr>
            <p:txBody>
              <a:bodyPr wrap="none" lIns="72000" tIns="0" rIns="36000" bIns="0" rtlCol="0">
                <a:spAutoFit/>
              </a:bodyPr>
              <a:lstStyle/>
              <a:p>
                <a:r>
                  <a:rPr kumimoji="1" lang="en-US" altLang="ja-JP" dirty="0" smtClean="0">
                    <a:latin typeface="Arial Narrow" panose="020B0606020202030204" pitchFamily="34" charset="0"/>
                    <a:cs typeface="Arial" panose="020B0604020202020204" pitchFamily="34" charset="0"/>
                  </a:rPr>
                  <a:t>g</a:t>
                </a:r>
                <a:endParaRPr kumimoji="1" lang="ja-JP" altLang="en-US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57" name="グラフ 5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51733487"/>
                  </p:ext>
                </p:extLst>
              </p:nvPr>
            </p:nvGraphicFramePr>
            <p:xfrm>
              <a:off x="286590" y="8988163"/>
              <a:ext cx="4500000" cy="2952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</p:grpSp>
        <p:grpSp>
          <p:nvGrpSpPr>
            <p:cNvPr id="22" name="グループ化 21"/>
            <p:cNvGrpSpPr/>
            <p:nvPr/>
          </p:nvGrpSpPr>
          <p:grpSpPr>
            <a:xfrm>
              <a:off x="4925825" y="8988163"/>
              <a:ext cx="4500000" cy="2952000"/>
              <a:chOff x="4804802" y="8946521"/>
              <a:chExt cx="4500000" cy="2952000"/>
            </a:xfrm>
          </p:grpSpPr>
          <p:sp>
            <p:nvSpPr>
              <p:cNvPr id="46" name="テキスト ボックス 45"/>
              <p:cNvSpPr txBox="1"/>
              <p:nvPr/>
            </p:nvSpPr>
            <p:spPr>
              <a:xfrm>
                <a:off x="4804802" y="8946521"/>
                <a:ext cx="214853" cy="276999"/>
              </a:xfrm>
              <a:prstGeom prst="rect">
                <a:avLst/>
              </a:prstGeom>
              <a:noFill/>
            </p:spPr>
            <p:txBody>
              <a:bodyPr wrap="none" lIns="72000" tIns="0" rIns="36000" bIns="0" rtlCol="0">
                <a:spAutoFit/>
              </a:bodyPr>
              <a:lstStyle/>
              <a:p>
                <a:r>
                  <a:rPr kumimoji="1" lang="en-US" altLang="ja-JP" dirty="0" smtClean="0">
                    <a:latin typeface="Arial Narrow" panose="020B0606020202030204" pitchFamily="34" charset="0"/>
                    <a:cs typeface="Arial" panose="020B0604020202020204" pitchFamily="34" charset="0"/>
                  </a:rPr>
                  <a:t>h</a:t>
                </a:r>
                <a:endParaRPr kumimoji="1" lang="ja-JP" altLang="en-US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58" name="グラフ 5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601483803"/>
                  </p:ext>
                </p:extLst>
              </p:nvPr>
            </p:nvGraphicFramePr>
            <p:xfrm>
              <a:off x="4804802" y="8946521"/>
              <a:ext cx="4500000" cy="2952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</p:grpSp>
        <p:sp>
          <p:nvSpPr>
            <p:cNvPr id="59" name="テキスト ボックス 5"/>
            <p:cNvSpPr txBox="1"/>
            <p:nvPr/>
          </p:nvSpPr>
          <p:spPr>
            <a:xfrm>
              <a:off x="1424712" y="11930913"/>
              <a:ext cx="6813084" cy="276999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ja-JP" altLang="en-US" dirty="0">
                  <a:latin typeface="Arial" panose="020B0604020202020204" pitchFamily="34" charset="0"/>
                  <a:cs typeface="Arial" panose="020B0604020202020204" pitchFamily="34" charset="0"/>
                </a:rPr>
                <a:t>　</a:t>
              </a:r>
              <a:r>
                <a:rPr kumimoji="1" lang="ja-JP" altLang="en-US" sz="1200" dirty="0">
                  <a:solidFill>
                    <a:schemeClr val="accent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■</a:t>
              </a:r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Agree</a:t>
              </a:r>
              <a:r>
                <a:rPr kumimoji="1" lang="ja-JP" altLang="en-US" dirty="0">
                  <a:latin typeface="Arial" panose="020B0604020202020204" pitchFamily="34" charset="0"/>
                  <a:cs typeface="Arial" panose="020B0604020202020204" pitchFamily="34" charset="0"/>
                </a:rPr>
                <a:t>　　</a:t>
              </a:r>
              <a:r>
                <a:rPr kumimoji="1" lang="ja-JP" altLang="ja-JP" sz="1200" dirty="0">
                  <a:solidFill>
                    <a:schemeClr val="accent1">
                      <a:lumMod val="60000"/>
                      <a:lumOff val="40000"/>
                    </a:schemeClr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■</a:t>
              </a:r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Somewhat agree</a:t>
              </a:r>
              <a:r>
                <a:rPr kumimoji="1" lang="ja-JP" altLang="en-US" dirty="0">
                  <a:latin typeface="Arial" panose="020B0604020202020204" pitchFamily="34" charset="0"/>
                  <a:cs typeface="Arial" panose="020B0604020202020204" pitchFamily="34" charset="0"/>
                </a:rPr>
                <a:t>　　</a:t>
              </a:r>
              <a:r>
                <a:rPr kumimoji="1" lang="ja-JP" altLang="ja-JP" sz="1200" dirty="0">
                  <a:solidFill>
                    <a:schemeClr val="bg1">
                      <a:lumMod val="85000"/>
                    </a:schemeClr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■</a:t>
              </a:r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Neither agree nor disagree</a:t>
              </a:r>
              <a:r>
                <a:rPr kumimoji="1" lang="ja-JP" altLang="en-US" dirty="0">
                  <a:latin typeface="Arial" panose="020B0604020202020204" pitchFamily="34" charset="0"/>
                  <a:cs typeface="Arial" panose="020B0604020202020204" pitchFamily="34" charset="0"/>
                </a:rPr>
                <a:t>　　</a:t>
              </a:r>
              <a:r>
                <a:rPr kumimoji="1" lang="ja-JP" altLang="ja-JP" sz="1200" dirty="0">
                  <a:solidFill>
                    <a:schemeClr val="accent2">
                      <a:lumMod val="40000"/>
                      <a:lumOff val="60000"/>
                    </a:schemeClr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■</a:t>
              </a:r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Somewhat disagree</a:t>
              </a:r>
              <a:r>
                <a:rPr kumimoji="1" lang="ja-JP" altLang="en-US" dirty="0">
                  <a:latin typeface="Arial" panose="020B0604020202020204" pitchFamily="34" charset="0"/>
                  <a:cs typeface="Arial" panose="020B0604020202020204" pitchFamily="34" charset="0"/>
                </a:rPr>
                <a:t>　　</a:t>
              </a:r>
              <a:r>
                <a:rPr kumimoji="1" lang="ja-JP" altLang="ja-JP" sz="1200" dirty="0">
                  <a:solidFill>
                    <a:schemeClr val="accent2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■</a:t>
              </a:r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Disagree 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366932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3</TotalTime>
  <Words>172</Words>
  <Application>Microsoft Office PowerPoint</Application>
  <PresentationFormat>A3 297x420 mm</PresentationFormat>
  <Paragraphs>1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gai A</dc:creator>
  <cp:lastModifiedBy>JHG</cp:lastModifiedBy>
  <cp:revision>32</cp:revision>
  <cp:lastPrinted>2018-12-18T06:44:51Z</cp:lastPrinted>
  <dcterms:created xsi:type="dcterms:W3CDTF">2018-11-09T07:08:19Z</dcterms:created>
  <dcterms:modified xsi:type="dcterms:W3CDTF">2018-12-18T07:54:03Z</dcterms:modified>
</cp:coreProperties>
</file>